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508\OneDrive%20-%20Istituti%20Fisioterapici%20Ospitalieri\Documenti\SUBMISSIONS\2021%20Alfonso%20DiCOSTANZO\Manuscript%20bundle%2020210906\Unificato%20nuovo%20corretto-4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508\OneDrive%20-%20Istituti%20Fisioterapici%20Ospitalieri\Documenti\SUBMISSIONS\2021%20Alfonso%20DiCOSTANZO\Manuscript%20bundle%2020210906\Unificato%20nuovo%20corretto-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508\OneDrive%20-%20Istituti%20Fisioterapici%20Ospitalieri\Documenti\SUBMISSIONS\2021%20Alfonso%20DiCOSTANZO\Manuscript%20bundle%2020210906\Unificato%20nuovo%20corretto-4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508\OneDrive%20-%20Istituti%20Fisioterapici%20Ospitalieri\Documenti\SUBMISSIONS\2021%20Alfonso%20DiCOSTANZO\Manuscript%20bundle%2020210906\Unificato%20nuovo%20corretto-4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(C18:1/C18:0)</a:t>
            </a:r>
          </a:p>
        </c:rich>
      </c:tx>
      <c:layout>
        <c:manualLayout>
          <c:xMode val="edge"/>
          <c:yMode val="edge"/>
          <c:x val="0.40813259453679401"/>
          <c:y val="3.571428571428571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xMode val="edge"/>
          <c:yMode val="edge"/>
          <c:x val="7.1589627685428217E-2"/>
          <c:y val="0.16406761654793151"/>
          <c:w val="0.89445975503062114"/>
          <c:h val="0.71688476440444926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7'!$A$1:$A$24</c:f>
              <c:numCache>
                <c:formatCode>General</c:formatCode>
                <c:ptCount val="24"/>
                <c:pt idx="0">
                  <c:v>1</c:v>
                </c:pt>
                <c:pt idx="1">
                  <c:v>0.8</c:v>
                </c:pt>
                <c:pt idx="2">
                  <c:v>1.2</c:v>
                </c:pt>
                <c:pt idx="3">
                  <c:v>0.85</c:v>
                </c:pt>
                <c:pt idx="4">
                  <c:v>1.1499999999999999</c:v>
                </c:pt>
                <c:pt idx="5">
                  <c:v>0.9</c:v>
                </c:pt>
                <c:pt idx="6">
                  <c:v>1.1000000000000001</c:v>
                </c:pt>
                <c:pt idx="7">
                  <c:v>0.95</c:v>
                </c:pt>
                <c:pt idx="8">
                  <c:v>1.05</c:v>
                </c:pt>
                <c:pt idx="9">
                  <c:v>1</c:v>
                </c:pt>
                <c:pt idx="10">
                  <c:v>0.93333333333333335</c:v>
                </c:pt>
                <c:pt idx="11">
                  <c:v>1.0666666666666667</c:v>
                </c:pt>
                <c:pt idx="12">
                  <c:v>1</c:v>
                </c:pt>
                <c:pt idx="13">
                  <c:v>0.88888888888888884</c:v>
                </c:pt>
                <c:pt idx="14">
                  <c:v>1.1111111111111112</c:v>
                </c:pt>
                <c:pt idx="15">
                  <c:v>0.94444444444444442</c:v>
                </c:pt>
                <c:pt idx="16">
                  <c:v>1.0555555555555556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0.93333333333333335</c:v>
                </c:pt>
                <c:pt idx="22">
                  <c:v>1.0666666666666667</c:v>
                </c:pt>
                <c:pt idx="23">
                  <c:v>1</c:v>
                </c:pt>
              </c:numCache>
            </c:numRef>
          </c:xVal>
          <c:yVal>
            <c:numRef>
              <c:f>'Kruskal-Wallis_HID17'!$B$1:$B$24</c:f>
              <c:numCache>
                <c:formatCode>General</c:formatCode>
                <c:ptCount val="24"/>
                <c:pt idx="0">
                  <c:v>0.15333805000502135</c:v>
                </c:pt>
                <c:pt idx="1">
                  <c:v>0.21830996623248505</c:v>
                </c:pt>
                <c:pt idx="2">
                  <c:v>0.28643886484169712</c:v>
                </c:pt>
                <c:pt idx="3">
                  <c:v>0.32909544833904314</c:v>
                </c:pt>
                <c:pt idx="4">
                  <c:v>0.33814960301560198</c:v>
                </c:pt>
                <c:pt idx="5">
                  <c:v>0.34353945695430183</c:v>
                </c:pt>
                <c:pt idx="6">
                  <c:v>0.39141577909291903</c:v>
                </c:pt>
                <c:pt idx="7">
                  <c:v>0.41112642585084497</c:v>
                </c:pt>
                <c:pt idx="8">
                  <c:v>0.46351663502877644</c:v>
                </c:pt>
                <c:pt idx="9">
                  <c:v>0.52962473369200769</c:v>
                </c:pt>
                <c:pt idx="10">
                  <c:v>0.53792942345528705</c:v>
                </c:pt>
                <c:pt idx="11">
                  <c:v>0.74027497502211592</c:v>
                </c:pt>
                <c:pt idx="12">
                  <c:v>0.8766982034995523</c:v>
                </c:pt>
                <c:pt idx="13">
                  <c:v>0.954455976806446</c:v>
                </c:pt>
                <c:pt idx="14">
                  <c:v>1.0095443736232232</c:v>
                </c:pt>
                <c:pt idx="15">
                  <c:v>1.0193889552929496</c:v>
                </c:pt>
                <c:pt idx="16">
                  <c:v>1.0898010216574148</c:v>
                </c:pt>
                <c:pt idx="17">
                  <c:v>1.2214854910494175</c:v>
                </c:pt>
                <c:pt idx="18">
                  <c:v>1.4433265923568304</c:v>
                </c:pt>
                <c:pt idx="19">
                  <c:v>2.0099192383078437</c:v>
                </c:pt>
                <c:pt idx="20">
                  <c:v>2.140518248008358</c:v>
                </c:pt>
                <c:pt idx="21">
                  <c:v>2.3169992148857648</c:v>
                </c:pt>
                <c:pt idx="22">
                  <c:v>2.3497674233121639</c:v>
                </c:pt>
                <c:pt idx="23">
                  <c:v>2.69396709183334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310-4B2C-B58B-9021623E388B}"/>
            </c:ext>
          </c:extLst>
        </c:ser>
        <c:ser>
          <c:idx val="1"/>
          <c:order val="1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7'!$C$1:$C$20</c:f>
              <c:numCache>
                <c:formatCode>General</c:formatCode>
                <c:ptCount val="20"/>
                <c:pt idx="0">
                  <c:v>2</c:v>
                </c:pt>
                <c:pt idx="1">
                  <c:v>1.8</c:v>
                </c:pt>
                <c:pt idx="2">
                  <c:v>2.2000000000000002</c:v>
                </c:pt>
                <c:pt idx="3">
                  <c:v>1.9</c:v>
                </c:pt>
                <c:pt idx="4">
                  <c:v>2.1</c:v>
                </c:pt>
                <c:pt idx="5">
                  <c:v>2.08</c:v>
                </c:pt>
                <c:pt idx="6">
                  <c:v>1.92</c:v>
                </c:pt>
                <c:pt idx="7">
                  <c:v>2</c:v>
                </c:pt>
                <c:pt idx="8">
                  <c:v>1.88</c:v>
                </c:pt>
                <c:pt idx="9">
                  <c:v>2.12</c:v>
                </c:pt>
                <c:pt idx="10">
                  <c:v>2</c:v>
                </c:pt>
                <c:pt idx="11">
                  <c:v>2</c:v>
                </c:pt>
                <c:pt idx="12">
                  <c:v>2</c:v>
                </c:pt>
                <c:pt idx="13">
                  <c:v>2</c:v>
                </c:pt>
                <c:pt idx="14">
                  <c:v>1.88</c:v>
                </c:pt>
                <c:pt idx="15">
                  <c:v>2.12</c:v>
                </c:pt>
                <c:pt idx="16">
                  <c:v>2.16</c:v>
                </c:pt>
                <c:pt idx="17">
                  <c:v>1.84</c:v>
                </c:pt>
                <c:pt idx="18">
                  <c:v>2.0533333333333332</c:v>
                </c:pt>
                <c:pt idx="19">
                  <c:v>1.9466666666666668</c:v>
                </c:pt>
              </c:numCache>
            </c:numRef>
          </c:xVal>
          <c:yVal>
            <c:numRef>
              <c:f>'Kruskal-Wallis_HID17'!$D$1:$D$20</c:f>
              <c:numCache>
                <c:formatCode>General</c:formatCode>
                <c:ptCount val="20"/>
                <c:pt idx="0">
                  <c:v>0.26660835267664906</c:v>
                </c:pt>
                <c:pt idx="1">
                  <c:v>0.32939748588277856</c:v>
                </c:pt>
                <c:pt idx="2">
                  <c:v>0.41119189638772313</c:v>
                </c:pt>
                <c:pt idx="3">
                  <c:v>0.46204087158761054</c:v>
                </c:pt>
                <c:pt idx="4">
                  <c:v>0.50758916582653246</c:v>
                </c:pt>
                <c:pt idx="5">
                  <c:v>0.5224071374947219</c:v>
                </c:pt>
                <c:pt idx="6">
                  <c:v>0.56503099257950051</c:v>
                </c:pt>
                <c:pt idx="7">
                  <c:v>0.92389679757612808</c:v>
                </c:pt>
                <c:pt idx="8">
                  <c:v>0.94981725407830042</c:v>
                </c:pt>
                <c:pt idx="9">
                  <c:v>0.98455158813728971</c:v>
                </c:pt>
                <c:pt idx="10">
                  <c:v>1.1543817123512035</c:v>
                </c:pt>
                <c:pt idx="11">
                  <c:v>1.3763362615106129</c:v>
                </c:pt>
                <c:pt idx="12">
                  <c:v>1.5600315118906143</c:v>
                </c:pt>
                <c:pt idx="13">
                  <c:v>1.7994043045021768</c:v>
                </c:pt>
                <c:pt idx="14">
                  <c:v>1.877364399650735</c:v>
                </c:pt>
                <c:pt idx="15">
                  <c:v>1.8963274987332825</c:v>
                </c:pt>
                <c:pt idx="16">
                  <c:v>2.101318281997139</c:v>
                </c:pt>
                <c:pt idx="17">
                  <c:v>2.113851732001184</c:v>
                </c:pt>
                <c:pt idx="18">
                  <c:v>2.1938134902043611</c:v>
                </c:pt>
                <c:pt idx="19">
                  <c:v>2.21213388007082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310-4B2C-B58B-9021623E388B}"/>
            </c:ext>
          </c:extLst>
        </c:ser>
        <c:ser>
          <c:idx val="2"/>
          <c:order val="2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7'!$E$1:$E$20</c:f>
              <c:numCache>
                <c:formatCode>General</c:formatCode>
                <c:ptCount val="20"/>
                <c:pt idx="0">
                  <c:v>3.0571428571428569</c:v>
                </c:pt>
                <c:pt idx="1">
                  <c:v>2.9428571428571431</c:v>
                </c:pt>
                <c:pt idx="2">
                  <c:v>3</c:v>
                </c:pt>
                <c:pt idx="3">
                  <c:v>2.9142857142857141</c:v>
                </c:pt>
                <c:pt idx="4">
                  <c:v>3.0857142857142859</c:v>
                </c:pt>
                <c:pt idx="5">
                  <c:v>3.0571428571428569</c:v>
                </c:pt>
                <c:pt idx="6">
                  <c:v>2.9428571428571431</c:v>
                </c:pt>
                <c:pt idx="7">
                  <c:v>3</c:v>
                </c:pt>
                <c:pt idx="8">
                  <c:v>2.8</c:v>
                </c:pt>
                <c:pt idx="9">
                  <c:v>3.2</c:v>
                </c:pt>
                <c:pt idx="10">
                  <c:v>2.8666666666666667</c:v>
                </c:pt>
                <c:pt idx="11">
                  <c:v>3.1333333333333333</c:v>
                </c:pt>
                <c:pt idx="12">
                  <c:v>2.9333333333333331</c:v>
                </c:pt>
                <c:pt idx="13">
                  <c:v>3.0666666666666669</c:v>
                </c:pt>
                <c:pt idx="14">
                  <c:v>3</c:v>
                </c:pt>
                <c:pt idx="15">
                  <c:v>3.0571428571428569</c:v>
                </c:pt>
                <c:pt idx="16">
                  <c:v>2.9428571428571431</c:v>
                </c:pt>
                <c:pt idx="17">
                  <c:v>3.0571428571428569</c:v>
                </c:pt>
                <c:pt idx="18">
                  <c:v>2.9428571428571431</c:v>
                </c:pt>
                <c:pt idx="19">
                  <c:v>3</c:v>
                </c:pt>
              </c:numCache>
            </c:numRef>
          </c:xVal>
          <c:yVal>
            <c:numRef>
              <c:f>'Kruskal-Wallis_HID17'!$F$1:$F$20</c:f>
              <c:numCache>
                <c:formatCode>General</c:formatCode>
                <c:ptCount val="20"/>
                <c:pt idx="0">
                  <c:v>0.52583207854135361</c:v>
                </c:pt>
                <c:pt idx="1">
                  <c:v>0.54259866098676568</c:v>
                </c:pt>
                <c:pt idx="2">
                  <c:v>0.94620076296889122</c:v>
                </c:pt>
                <c:pt idx="3">
                  <c:v>1.0651212426668213</c:v>
                </c:pt>
                <c:pt idx="4">
                  <c:v>1.1365383962982378</c:v>
                </c:pt>
                <c:pt idx="5">
                  <c:v>1.4729442418217078</c:v>
                </c:pt>
                <c:pt idx="6">
                  <c:v>1.5350177296723164</c:v>
                </c:pt>
                <c:pt idx="7">
                  <c:v>1.6169464576064632</c:v>
                </c:pt>
                <c:pt idx="8">
                  <c:v>1.6979987537207593</c:v>
                </c:pt>
                <c:pt idx="9">
                  <c:v>1.7004044143873269</c:v>
                </c:pt>
                <c:pt idx="10">
                  <c:v>1.7043321379238483</c:v>
                </c:pt>
                <c:pt idx="11">
                  <c:v>1.805406964667833</c:v>
                </c:pt>
                <c:pt idx="12">
                  <c:v>1.862655199800954</c:v>
                </c:pt>
                <c:pt idx="13">
                  <c:v>1.8781609184748034</c:v>
                </c:pt>
                <c:pt idx="14">
                  <c:v>2.0839528049485745</c:v>
                </c:pt>
                <c:pt idx="15">
                  <c:v>2.4512649425740611</c:v>
                </c:pt>
                <c:pt idx="16">
                  <c:v>2.5155565963766247</c:v>
                </c:pt>
                <c:pt idx="17">
                  <c:v>2.7209636757067952</c:v>
                </c:pt>
                <c:pt idx="18">
                  <c:v>2.7692705641589681</c:v>
                </c:pt>
                <c:pt idx="19">
                  <c:v>3.28457779151249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310-4B2C-B58B-9021623E388B}"/>
            </c:ext>
          </c:extLst>
        </c:ser>
        <c:ser>
          <c:idx val="3"/>
          <c:order val="3"/>
          <c:tx>
            <c:v>Mea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2"/>
            <c:spPr>
              <a:solidFill>
                <a:srgbClr val="FFFF0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Lit>
              <c:formatCode>General</c:formatCode>
              <c:ptCount val="3"/>
              <c:pt idx="0">
                <c:v>1</c:v>
              </c:pt>
              <c:pt idx="1">
                <c:v>2</c:v>
              </c:pt>
              <c:pt idx="2">
                <c:v>3</c:v>
              </c:pt>
            </c:numLit>
          </c:xVal>
          <c:yVal>
            <c:numLit>
              <c:formatCode>General</c:formatCode>
              <c:ptCount val="3"/>
              <c:pt idx="0">
                <c:v>0.9945262996734755</c:v>
              </c:pt>
              <c:pt idx="1">
                <c:v>1.2103747307569683</c:v>
              </c:pt>
              <c:pt idx="2">
                <c:v>1.76578721674078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D310-4B2C-B58B-9021623E388B}"/>
            </c:ext>
          </c:extLst>
        </c:ser>
        <c:ser>
          <c:idx val="4"/>
          <c:order val="4"/>
          <c:tx>
            <c:v>Median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dPt>
            <c:idx val="2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5-D310-4B2C-B58B-9021623E388B}"/>
              </c:ext>
            </c:extLst>
          </c:dPt>
          <c:dPt>
            <c:idx val="4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7-D310-4B2C-B58B-9021623E388B}"/>
              </c:ext>
            </c:extLst>
          </c:dPt>
          <c:xVal>
            <c:numLit>
              <c:formatCode>General</c:formatCode>
              <c:ptCount val="6"/>
              <c:pt idx="0">
                <c:v>0.75</c:v>
              </c:pt>
              <c:pt idx="1">
                <c:v>1.25</c:v>
              </c:pt>
              <c:pt idx="2">
                <c:v>1.75</c:v>
              </c:pt>
              <c:pt idx="3">
                <c:v>2.25</c:v>
              </c:pt>
              <c:pt idx="4">
                <c:v>2.75</c:v>
              </c:pt>
              <c:pt idx="5">
                <c:v>3.25</c:v>
              </c:pt>
            </c:numLit>
          </c:xVal>
          <c:yVal>
            <c:numLit>
              <c:formatCode>General</c:formatCode>
              <c:ptCount val="6"/>
              <c:pt idx="0">
                <c:v>0.80848658926083417</c:v>
              </c:pt>
              <c:pt idx="1">
                <c:v>0.80848658926083417</c:v>
              </c:pt>
              <c:pt idx="2">
                <c:v>1.0694666502442467</c:v>
              </c:pt>
              <c:pt idx="3">
                <c:v>1.0694666502442467</c:v>
              </c:pt>
              <c:pt idx="4">
                <c:v>1.7023682761555876</c:v>
              </c:pt>
              <c:pt idx="5">
                <c:v>1.7023682761555876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8-D310-4B2C-B58B-9021623E388B}"/>
            </c:ext>
          </c:extLst>
        </c:ser>
        <c:ser>
          <c:idx val="5"/>
          <c:order val="5"/>
          <c:tx>
            <c:v/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D310-4B2C-B58B-9021623E388B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A-D310-4B2C-B58B-9021623E388B}"/>
                </c:ext>
              </c:extLst>
            </c:dLbl>
            <c:dLbl>
              <c:idx val="2"/>
              <c:layout>
                <c:manualLayout>
                  <c:x val="-6.1898269660736853E-2"/>
                  <c:y val="-2.48909511311086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295</a:t>
                    </a:r>
                    <a:endParaRPr lang="en-US" dirty="0"/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D310-4B2C-B58B-9021623E388B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C-D310-4B2C-B58B-9021623E388B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D-D310-4B2C-B58B-9021623E388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1.0249999999999999</c:v>
              </c:pt>
              <c:pt idx="1">
                <c:v>1.0249999999999999</c:v>
              </c:pt>
              <c:pt idx="2">
                <c:v>1.5</c:v>
              </c:pt>
              <c:pt idx="3">
                <c:v>1.9750000000000001</c:v>
              </c:pt>
              <c:pt idx="4">
                <c:v>1.9750000000000001</c:v>
              </c:pt>
            </c:numLit>
          </c:xVal>
          <c:yVal>
            <c:numLit>
              <c:formatCode>General</c:formatCode>
              <c:ptCount val="5"/>
              <c:pt idx="0">
                <c:v>3.6</c:v>
              </c:pt>
              <c:pt idx="1">
                <c:v>3.7</c:v>
              </c:pt>
              <c:pt idx="2">
                <c:v>3.7</c:v>
              </c:pt>
              <c:pt idx="3">
                <c:v>3.7</c:v>
              </c:pt>
              <c:pt idx="4">
                <c:v>3.6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E-D310-4B2C-B58B-9021623E388B}"/>
            </c:ext>
          </c:extLst>
        </c:ser>
        <c:ser>
          <c:idx val="6"/>
          <c:order val="6"/>
          <c:tx>
            <c:v/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F-D310-4B2C-B58B-9021623E388B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0-D310-4B2C-B58B-9021623E388B}"/>
                </c:ext>
              </c:extLst>
            </c:dLbl>
            <c:dLbl>
              <c:idx val="2"/>
              <c:layout>
                <c:manualLayout>
                  <c:x val="-6.1898269660736853E-2"/>
                  <c:y val="-2.48909511311086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041</a:t>
                    </a:r>
                    <a:endParaRPr lang="en-US" dirty="0"/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1-D310-4B2C-B58B-9021623E388B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2-D310-4B2C-B58B-9021623E388B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3-D310-4B2C-B58B-9021623E388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2.0249999999999999</c:v>
              </c:pt>
              <c:pt idx="1">
                <c:v>2.0249999999999999</c:v>
              </c:pt>
              <c:pt idx="2">
                <c:v>2.5</c:v>
              </c:pt>
              <c:pt idx="3">
                <c:v>2.9750000000000001</c:v>
              </c:pt>
              <c:pt idx="4">
                <c:v>2.9750000000000001</c:v>
              </c:pt>
            </c:numLit>
          </c:xVal>
          <c:yVal>
            <c:numLit>
              <c:formatCode>General</c:formatCode>
              <c:ptCount val="5"/>
              <c:pt idx="0">
                <c:v>3.6</c:v>
              </c:pt>
              <c:pt idx="1">
                <c:v>3.7</c:v>
              </c:pt>
              <c:pt idx="2">
                <c:v>3.7</c:v>
              </c:pt>
              <c:pt idx="3">
                <c:v>3.7</c:v>
              </c:pt>
              <c:pt idx="4">
                <c:v>3.6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4-D310-4B2C-B58B-9021623E388B}"/>
            </c:ext>
          </c:extLst>
        </c:ser>
        <c:ser>
          <c:idx val="7"/>
          <c:order val="7"/>
          <c:tx>
            <c:v/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5-D310-4B2C-B58B-9021623E388B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6-D310-4B2C-B58B-9021623E388B}"/>
                </c:ext>
              </c:extLst>
            </c:dLbl>
            <c:dLbl>
              <c:idx val="2"/>
              <c:layout>
                <c:manualLayout>
                  <c:x val="-6.7276416836784286E-2"/>
                  <c:y val="-2.4890951131108646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001</a:t>
                    </a:r>
                    <a:r>
                      <a:rPr lang="en-US" dirty="0"/>
                      <a:t>*</a:t>
                    </a:r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7-D310-4B2C-B58B-9021623E388B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8-D310-4B2C-B58B-9021623E388B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9-D310-4B2C-B58B-9021623E388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1.0249999999999999</c:v>
              </c:pt>
              <c:pt idx="1">
                <c:v>1.0249999999999999</c:v>
              </c:pt>
              <c:pt idx="2">
                <c:v>2</c:v>
              </c:pt>
              <c:pt idx="3">
                <c:v>2.9750000000000001</c:v>
              </c:pt>
              <c:pt idx="4">
                <c:v>2.9750000000000001</c:v>
              </c:pt>
            </c:numLit>
          </c:xVal>
          <c:yVal>
            <c:numLit>
              <c:formatCode>General</c:formatCode>
              <c:ptCount val="5"/>
              <c:pt idx="0">
                <c:v>3.9000000000000004</c:v>
              </c:pt>
              <c:pt idx="1">
                <c:v>4</c:v>
              </c:pt>
              <c:pt idx="2">
                <c:v>4</c:v>
              </c:pt>
              <c:pt idx="3">
                <c:v>4</c:v>
              </c:pt>
              <c:pt idx="4">
                <c:v>3.9000000000000004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A-D310-4B2C-B58B-9021623E388B}"/>
            </c:ext>
          </c:extLst>
        </c:ser>
        <c:ser>
          <c:idx val="8"/>
          <c:order val="8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HS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B-D310-4B2C-B58B-9021623E388B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AD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C-D310-4B2C-B58B-9021623E388B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PD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D-D310-4B2C-B58B-9021623E388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3"/>
              <c:pt idx="0">
                <c:v>1</c:v>
              </c:pt>
              <c:pt idx="1">
                <c:v>2</c:v>
              </c:pt>
              <c:pt idx="2">
                <c:v>3</c:v>
              </c:pt>
            </c:numLit>
          </c:xVal>
          <c:yVal>
            <c:numLit>
              <c:formatCode>General</c:formatCode>
              <c:ptCount val="3"/>
              <c:pt idx="0">
                <c:v>0.105</c:v>
              </c:pt>
              <c:pt idx="1">
                <c:v>0.105</c:v>
              </c:pt>
              <c:pt idx="2">
                <c:v>0.10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E-D310-4B2C-B58B-9021623E38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2189247"/>
        <c:axId val="1462173439"/>
      </c:scatterChart>
      <c:valAx>
        <c:axId val="1462189247"/>
        <c:scaling>
          <c:orientation val="minMax"/>
          <c:max val="3.5"/>
          <c:min val="0.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2173439"/>
        <c:crosses val="autoZero"/>
        <c:crossBetween val="midCat"/>
      </c:valAx>
      <c:valAx>
        <c:axId val="1462173439"/>
        <c:scaling>
          <c:orientation val="minMax"/>
          <c:max val="4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 smtClean="0"/>
                  <a:t>Ratio</a:t>
                </a:r>
                <a:endParaRPr lang="en-GB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2189247"/>
        <c:crossesAt val="0.5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(C17:1/C17:0)</a:t>
            </a:r>
          </a:p>
        </c:rich>
      </c:tx>
      <c:layout>
        <c:manualLayout>
          <c:xMode val="edge"/>
          <c:yMode val="edge"/>
          <c:x val="0.40199061922815205"/>
          <c:y val="3.9682539682539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xMode val="edge"/>
          <c:yMode val="edge"/>
          <c:x val="7.1589627685428217E-2"/>
          <c:y val="0.16406761654793151"/>
          <c:w val="0.89445975503062114"/>
          <c:h val="0.79624984376952868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6'!$A$1:$A$24</c:f>
              <c:numCache>
                <c:formatCode>General</c:formatCode>
                <c:ptCount val="24"/>
                <c:pt idx="0">
                  <c:v>1.0571428571428572</c:v>
                </c:pt>
                <c:pt idx="1">
                  <c:v>0.94285714285714284</c:v>
                </c:pt>
                <c:pt idx="2">
                  <c:v>1.0571428571428572</c:v>
                </c:pt>
                <c:pt idx="3">
                  <c:v>0.94285714285714284</c:v>
                </c:pt>
                <c:pt idx="4">
                  <c:v>1</c:v>
                </c:pt>
                <c:pt idx="5">
                  <c:v>0.91428571428571426</c:v>
                </c:pt>
                <c:pt idx="6">
                  <c:v>1.0857142857142856</c:v>
                </c:pt>
                <c:pt idx="7">
                  <c:v>1</c:v>
                </c:pt>
                <c:pt idx="8">
                  <c:v>0.91428571428571426</c:v>
                </c:pt>
                <c:pt idx="9">
                  <c:v>1.0857142857142856</c:v>
                </c:pt>
                <c:pt idx="10">
                  <c:v>1</c:v>
                </c:pt>
                <c:pt idx="11">
                  <c:v>0.8</c:v>
                </c:pt>
                <c:pt idx="12">
                  <c:v>1.2</c:v>
                </c:pt>
                <c:pt idx="13">
                  <c:v>0.8666666666666667</c:v>
                </c:pt>
                <c:pt idx="14">
                  <c:v>1.1333333333333333</c:v>
                </c:pt>
                <c:pt idx="15">
                  <c:v>0.93333333333333335</c:v>
                </c:pt>
                <c:pt idx="16">
                  <c:v>1.0666666666666667</c:v>
                </c:pt>
                <c:pt idx="17">
                  <c:v>1</c:v>
                </c:pt>
                <c:pt idx="18">
                  <c:v>0.91428571428571426</c:v>
                </c:pt>
                <c:pt idx="19">
                  <c:v>1.0857142857142856</c:v>
                </c:pt>
                <c:pt idx="20">
                  <c:v>1.0571428571428572</c:v>
                </c:pt>
                <c:pt idx="21">
                  <c:v>0.94285714285714284</c:v>
                </c:pt>
                <c:pt idx="22">
                  <c:v>1.0571428571428572</c:v>
                </c:pt>
                <c:pt idx="23">
                  <c:v>0.94285714285714284</c:v>
                </c:pt>
              </c:numCache>
            </c:numRef>
          </c:xVal>
          <c:yVal>
            <c:numRef>
              <c:f>'Kruskal-Wallis_HID16'!$B$1:$B$24</c:f>
              <c:numCache>
                <c:formatCode>General</c:formatCode>
                <c:ptCount val="24"/>
                <c:pt idx="0">
                  <c:v>1.7767302036789868E-2</c:v>
                </c:pt>
                <c:pt idx="1">
                  <c:v>3.6527716106876676E-2</c:v>
                </c:pt>
                <c:pt idx="2">
                  <c:v>0.23529798761032891</c:v>
                </c:pt>
                <c:pt idx="3">
                  <c:v>0.25464382363034166</c:v>
                </c:pt>
                <c:pt idx="4">
                  <c:v>0.27861606399260685</c:v>
                </c:pt>
                <c:pt idx="5">
                  <c:v>0.3696320663883898</c:v>
                </c:pt>
                <c:pt idx="6">
                  <c:v>0.37775195821788488</c:v>
                </c:pt>
                <c:pt idx="7">
                  <c:v>0.42437753281937263</c:v>
                </c:pt>
                <c:pt idx="8">
                  <c:v>0.43553497637614291</c:v>
                </c:pt>
                <c:pt idx="9">
                  <c:v>0.45753003384827967</c:v>
                </c:pt>
                <c:pt idx="10">
                  <c:v>0.52930760069355087</c:v>
                </c:pt>
                <c:pt idx="11">
                  <c:v>0.57043918294171203</c:v>
                </c:pt>
                <c:pt idx="12">
                  <c:v>0.57367082451605078</c:v>
                </c:pt>
                <c:pt idx="13">
                  <c:v>0.59000758033408152</c:v>
                </c:pt>
                <c:pt idx="14">
                  <c:v>0.6013070310839016</c:v>
                </c:pt>
                <c:pt idx="15">
                  <c:v>0.61942872389908421</c:v>
                </c:pt>
                <c:pt idx="16">
                  <c:v>0.62786150644566252</c:v>
                </c:pt>
                <c:pt idx="17">
                  <c:v>0.68430285559154813</c:v>
                </c:pt>
                <c:pt idx="18">
                  <c:v>0.70879661274593531</c:v>
                </c:pt>
                <c:pt idx="19">
                  <c:v>0.73555104637039104</c:v>
                </c:pt>
                <c:pt idx="20">
                  <c:v>0.80757269551665578</c:v>
                </c:pt>
                <c:pt idx="21">
                  <c:v>0.8441134837156683</c:v>
                </c:pt>
                <c:pt idx="22">
                  <c:v>0.91066937689565886</c:v>
                </c:pt>
                <c:pt idx="23">
                  <c:v>0.999051546256747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80A-4C29-BAB2-3F668D80C57A}"/>
            </c:ext>
          </c:extLst>
        </c:ser>
        <c:ser>
          <c:idx val="1"/>
          <c:order val="1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6'!$C$1:$C$20</c:f>
              <c:numCache>
                <c:formatCode>General</c:formatCode>
                <c:ptCount val="20"/>
                <c:pt idx="0">
                  <c:v>2.08</c:v>
                </c:pt>
                <c:pt idx="1">
                  <c:v>1.92</c:v>
                </c:pt>
                <c:pt idx="2">
                  <c:v>2</c:v>
                </c:pt>
                <c:pt idx="3">
                  <c:v>1.8</c:v>
                </c:pt>
                <c:pt idx="4">
                  <c:v>2.2000000000000002</c:v>
                </c:pt>
                <c:pt idx="5">
                  <c:v>1.9</c:v>
                </c:pt>
                <c:pt idx="6">
                  <c:v>2.1</c:v>
                </c:pt>
                <c:pt idx="7">
                  <c:v>2</c:v>
                </c:pt>
                <c:pt idx="8">
                  <c:v>1.88</c:v>
                </c:pt>
                <c:pt idx="9">
                  <c:v>2.12</c:v>
                </c:pt>
                <c:pt idx="10">
                  <c:v>2</c:v>
                </c:pt>
                <c:pt idx="11">
                  <c:v>1.88</c:v>
                </c:pt>
                <c:pt idx="12">
                  <c:v>2.12</c:v>
                </c:pt>
                <c:pt idx="13">
                  <c:v>2.16</c:v>
                </c:pt>
                <c:pt idx="14">
                  <c:v>1.84</c:v>
                </c:pt>
                <c:pt idx="15">
                  <c:v>2.0533333333333332</c:v>
                </c:pt>
                <c:pt idx="16">
                  <c:v>1.9466666666666668</c:v>
                </c:pt>
                <c:pt idx="17">
                  <c:v>2</c:v>
                </c:pt>
                <c:pt idx="18">
                  <c:v>1.88</c:v>
                </c:pt>
                <c:pt idx="19">
                  <c:v>2.12</c:v>
                </c:pt>
              </c:numCache>
            </c:numRef>
          </c:xVal>
          <c:yVal>
            <c:numRef>
              <c:f>'Kruskal-Wallis_HID16'!$D$1:$D$20</c:f>
              <c:numCache>
                <c:formatCode>General</c:formatCode>
                <c:ptCount val="20"/>
                <c:pt idx="0">
                  <c:v>3.1321174124815374E-2</c:v>
                </c:pt>
                <c:pt idx="1">
                  <c:v>0.12610720676757317</c:v>
                </c:pt>
                <c:pt idx="2">
                  <c:v>0.3731915443087106</c:v>
                </c:pt>
                <c:pt idx="3">
                  <c:v>0.40187928392302408</c:v>
                </c:pt>
                <c:pt idx="4">
                  <c:v>0.40791133970507787</c:v>
                </c:pt>
                <c:pt idx="5">
                  <c:v>0.4127243437454598</c:v>
                </c:pt>
                <c:pt idx="6">
                  <c:v>0.46651376254222332</c:v>
                </c:pt>
                <c:pt idx="7">
                  <c:v>0.51311945644805568</c:v>
                </c:pt>
                <c:pt idx="8">
                  <c:v>0.54256442640372804</c:v>
                </c:pt>
                <c:pt idx="9">
                  <c:v>0.5890135908134978</c:v>
                </c:pt>
                <c:pt idx="10">
                  <c:v>0.62055452810673284</c:v>
                </c:pt>
                <c:pt idx="11">
                  <c:v>0.68614616874309142</c:v>
                </c:pt>
                <c:pt idx="12">
                  <c:v>0.68698066290315751</c:v>
                </c:pt>
                <c:pt idx="13">
                  <c:v>0.71793025243912145</c:v>
                </c:pt>
                <c:pt idx="14">
                  <c:v>0.73762977351093872</c:v>
                </c:pt>
                <c:pt idx="15">
                  <c:v>0.78003879899377349</c:v>
                </c:pt>
                <c:pt idx="16">
                  <c:v>0.7881340251643254</c:v>
                </c:pt>
                <c:pt idx="17">
                  <c:v>0.85412461402539408</c:v>
                </c:pt>
                <c:pt idx="18">
                  <c:v>0.90137342571458667</c:v>
                </c:pt>
                <c:pt idx="19">
                  <c:v>0.928166290354717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80A-4C29-BAB2-3F668D80C57A}"/>
            </c:ext>
          </c:extLst>
        </c:ser>
        <c:ser>
          <c:idx val="2"/>
          <c:order val="2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6'!$E$1:$E$20</c:f>
              <c:numCache>
                <c:formatCode>General</c:formatCode>
                <c:ptCount val="20"/>
                <c:pt idx="0">
                  <c:v>3</c:v>
                </c:pt>
                <c:pt idx="1">
                  <c:v>3</c:v>
                </c:pt>
                <c:pt idx="2">
                  <c:v>3.0666666666666669</c:v>
                </c:pt>
                <c:pt idx="3">
                  <c:v>2.9333333333333331</c:v>
                </c:pt>
                <c:pt idx="4">
                  <c:v>3</c:v>
                </c:pt>
                <c:pt idx="5">
                  <c:v>2.9</c:v>
                </c:pt>
                <c:pt idx="6">
                  <c:v>3.1</c:v>
                </c:pt>
                <c:pt idx="7">
                  <c:v>3.2</c:v>
                </c:pt>
                <c:pt idx="8">
                  <c:v>2.8</c:v>
                </c:pt>
                <c:pt idx="9">
                  <c:v>3.12</c:v>
                </c:pt>
                <c:pt idx="10">
                  <c:v>2.88</c:v>
                </c:pt>
                <c:pt idx="11">
                  <c:v>3.04</c:v>
                </c:pt>
                <c:pt idx="12">
                  <c:v>2.96</c:v>
                </c:pt>
                <c:pt idx="13">
                  <c:v>3.0666666666666669</c:v>
                </c:pt>
                <c:pt idx="14">
                  <c:v>2.9333333333333331</c:v>
                </c:pt>
                <c:pt idx="15">
                  <c:v>3</c:v>
                </c:pt>
                <c:pt idx="16">
                  <c:v>3.1333333333333333</c:v>
                </c:pt>
                <c:pt idx="17">
                  <c:v>2.8666666666666667</c:v>
                </c:pt>
                <c:pt idx="18">
                  <c:v>3.0444444444444443</c:v>
                </c:pt>
                <c:pt idx="19">
                  <c:v>2.9555555555555557</c:v>
                </c:pt>
              </c:numCache>
            </c:numRef>
          </c:xVal>
          <c:yVal>
            <c:numRef>
              <c:f>'Kruskal-Wallis_HID16'!$F$1:$F$20</c:f>
              <c:numCache>
                <c:formatCode>General</c:formatCode>
                <c:ptCount val="20"/>
                <c:pt idx="0">
                  <c:v>0.30021835152436555</c:v>
                </c:pt>
                <c:pt idx="1">
                  <c:v>0.42048291803604737</c:v>
                </c:pt>
                <c:pt idx="2">
                  <c:v>0.51046385157944085</c:v>
                </c:pt>
                <c:pt idx="3">
                  <c:v>0.53515288186241383</c:v>
                </c:pt>
                <c:pt idx="4">
                  <c:v>0.57662066514113897</c:v>
                </c:pt>
                <c:pt idx="5">
                  <c:v>0.59504044978606652</c:v>
                </c:pt>
                <c:pt idx="6">
                  <c:v>0.6108570105173482</c:v>
                </c:pt>
                <c:pt idx="7">
                  <c:v>0.6631242648843868</c:v>
                </c:pt>
                <c:pt idx="8">
                  <c:v>0.68886187240365282</c:v>
                </c:pt>
                <c:pt idx="9">
                  <c:v>0.69819437151064423</c:v>
                </c:pt>
                <c:pt idx="10">
                  <c:v>0.70878631184064222</c:v>
                </c:pt>
                <c:pt idx="11">
                  <c:v>0.70981545643946431</c:v>
                </c:pt>
                <c:pt idx="12">
                  <c:v>0.72377065488016068</c:v>
                </c:pt>
                <c:pt idx="13">
                  <c:v>0.75395411006684865</c:v>
                </c:pt>
                <c:pt idx="14">
                  <c:v>0.81118276136835588</c:v>
                </c:pt>
                <c:pt idx="15">
                  <c:v>0.8482178845218088</c:v>
                </c:pt>
                <c:pt idx="16">
                  <c:v>0.91205384379615073</c:v>
                </c:pt>
                <c:pt idx="17">
                  <c:v>0.91217065258681151</c:v>
                </c:pt>
                <c:pt idx="18">
                  <c:v>0.9125747927500113</c:v>
                </c:pt>
                <c:pt idx="19">
                  <c:v>0.981658794059405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80A-4C29-BAB2-3F668D80C57A}"/>
            </c:ext>
          </c:extLst>
        </c:ser>
        <c:ser>
          <c:idx val="3"/>
          <c:order val="3"/>
          <c:tx>
            <c:v>Mea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2"/>
            <c:spPr>
              <a:solidFill>
                <a:srgbClr val="FFFF0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Lit>
              <c:formatCode>General</c:formatCode>
              <c:ptCount val="3"/>
              <c:pt idx="0">
                <c:v>1</c:v>
              </c:pt>
              <c:pt idx="1">
                <c:v>2</c:v>
              </c:pt>
              <c:pt idx="2">
                <c:v>3</c:v>
              </c:pt>
            </c:numLit>
          </c:xVal>
          <c:yVal>
            <c:numLit>
              <c:formatCode>General</c:formatCode>
              <c:ptCount val="3"/>
              <c:pt idx="0">
                <c:v>0.52873998033473601</c:v>
              </c:pt>
              <c:pt idx="1">
                <c:v>0.57827123343690023</c:v>
              </c:pt>
              <c:pt idx="2">
                <c:v>0.69366009497775816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F80A-4C29-BAB2-3F668D80C57A}"/>
            </c:ext>
          </c:extLst>
        </c:ser>
        <c:ser>
          <c:idx val="4"/>
          <c:order val="4"/>
          <c:tx>
            <c:v>Median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dPt>
            <c:idx val="2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5-F80A-4C29-BAB2-3F668D80C57A}"/>
              </c:ext>
            </c:extLst>
          </c:dPt>
          <c:dPt>
            <c:idx val="4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7-F80A-4C29-BAB2-3F668D80C57A}"/>
              </c:ext>
            </c:extLst>
          </c:dPt>
          <c:xVal>
            <c:numLit>
              <c:formatCode>General</c:formatCode>
              <c:ptCount val="6"/>
              <c:pt idx="0">
                <c:v>0.75</c:v>
              </c:pt>
              <c:pt idx="1">
                <c:v>1.25</c:v>
              </c:pt>
              <c:pt idx="2">
                <c:v>1.75</c:v>
              </c:pt>
              <c:pt idx="3">
                <c:v>2.25</c:v>
              </c:pt>
              <c:pt idx="4">
                <c:v>2.75</c:v>
              </c:pt>
              <c:pt idx="5">
                <c:v>3.25</c:v>
              </c:pt>
            </c:numLit>
          </c:xVal>
          <c:yVal>
            <c:numLit>
              <c:formatCode>General</c:formatCode>
              <c:ptCount val="6"/>
              <c:pt idx="0">
                <c:v>0.57205500372888141</c:v>
              </c:pt>
              <c:pt idx="1">
                <c:v>0.57205500372888141</c:v>
              </c:pt>
              <c:pt idx="2">
                <c:v>0.60478405946011526</c:v>
              </c:pt>
              <c:pt idx="3">
                <c:v>0.60478405946011526</c:v>
              </c:pt>
              <c:pt idx="4">
                <c:v>0.70349034167564328</c:v>
              </c:pt>
              <c:pt idx="5">
                <c:v>0.70349034167564328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8-F80A-4C29-BAB2-3F668D80C57A}"/>
            </c:ext>
          </c:extLst>
        </c:ser>
        <c:ser>
          <c:idx val="5"/>
          <c:order val="5"/>
          <c:tx>
            <c:v/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F80A-4C29-BAB2-3F668D80C57A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A-F80A-4C29-BAB2-3F668D80C57A}"/>
                </c:ext>
              </c:extLst>
            </c:dLbl>
            <c:dLbl>
              <c:idx val="2"/>
              <c:layout>
                <c:manualLayout>
                  <c:x val="-6.1898269660736853E-2"/>
                  <c:y val="-2.48909511311086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445</a:t>
                    </a:r>
                    <a:endParaRPr lang="en-US" dirty="0"/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F80A-4C29-BAB2-3F668D80C57A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C-F80A-4C29-BAB2-3F668D80C57A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D-F80A-4C29-BAB2-3F668D80C57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1.0249999999999999</c:v>
              </c:pt>
              <c:pt idx="1">
                <c:v>1.0249999999999999</c:v>
              </c:pt>
              <c:pt idx="2">
                <c:v>1.5</c:v>
              </c:pt>
              <c:pt idx="3">
                <c:v>1.9750000000000001</c:v>
              </c:pt>
              <c:pt idx="4">
                <c:v>1.9750000000000001</c:v>
              </c:pt>
            </c:numLit>
          </c:xVal>
          <c:yVal>
            <c:numLit>
              <c:formatCode>General</c:formatCode>
              <c:ptCount val="5"/>
              <c:pt idx="0">
                <c:v>1.0285714285714285</c:v>
              </c:pt>
              <c:pt idx="1">
                <c:v>1.0571428571428569</c:v>
              </c:pt>
              <c:pt idx="2">
                <c:v>1.0571428571428569</c:v>
              </c:pt>
              <c:pt idx="3">
                <c:v>1.0571428571428569</c:v>
              </c:pt>
              <c:pt idx="4">
                <c:v>1.028571428571428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E-F80A-4C29-BAB2-3F668D80C57A}"/>
            </c:ext>
          </c:extLst>
        </c:ser>
        <c:ser>
          <c:idx val="6"/>
          <c:order val="6"/>
          <c:tx>
            <c:v/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F-F80A-4C29-BAB2-3F668D80C57A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0-F80A-4C29-BAB2-3F668D80C57A}"/>
                </c:ext>
              </c:extLst>
            </c:dLbl>
            <c:dLbl>
              <c:idx val="2"/>
              <c:layout>
                <c:manualLayout>
                  <c:x val="-6.1898269660736853E-2"/>
                  <c:y val="-2.48909511311086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133</a:t>
                    </a:r>
                    <a:endParaRPr lang="en-US" dirty="0"/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1-F80A-4C29-BAB2-3F668D80C57A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2-F80A-4C29-BAB2-3F668D80C57A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3-F80A-4C29-BAB2-3F668D80C57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2.0249999999999999</c:v>
              </c:pt>
              <c:pt idx="1">
                <c:v>2.0249999999999999</c:v>
              </c:pt>
              <c:pt idx="2">
                <c:v>2.5</c:v>
              </c:pt>
              <c:pt idx="3">
                <c:v>2.9750000000000001</c:v>
              </c:pt>
              <c:pt idx="4">
                <c:v>2.9750000000000001</c:v>
              </c:pt>
            </c:numLit>
          </c:xVal>
          <c:yVal>
            <c:numLit>
              <c:formatCode>General</c:formatCode>
              <c:ptCount val="5"/>
              <c:pt idx="0">
                <c:v>1.0285714285714285</c:v>
              </c:pt>
              <c:pt idx="1">
                <c:v>1.0571428571428569</c:v>
              </c:pt>
              <c:pt idx="2">
                <c:v>1.0571428571428569</c:v>
              </c:pt>
              <c:pt idx="3">
                <c:v>1.0571428571428569</c:v>
              </c:pt>
              <c:pt idx="4">
                <c:v>1.0285714285714285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4-F80A-4C29-BAB2-3F668D80C57A}"/>
            </c:ext>
          </c:extLst>
        </c:ser>
        <c:ser>
          <c:idx val="7"/>
          <c:order val="7"/>
          <c:tx>
            <c:v/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5-F80A-4C29-BAB2-3F668D80C57A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6-F80A-4C29-BAB2-3F668D80C57A}"/>
                </c:ext>
              </c:extLst>
            </c:dLbl>
            <c:dLbl>
              <c:idx val="2"/>
              <c:layout>
                <c:manualLayout>
                  <c:x val="-6.1898269660736853E-2"/>
                  <c:y val="-2.48909511311086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020</a:t>
                    </a:r>
                    <a:endParaRPr lang="en-US" dirty="0"/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7-F80A-4C29-BAB2-3F668D80C57A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8-F80A-4C29-BAB2-3F668D80C57A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9-F80A-4C29-BAB2-3F668D80C57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1.0249999999999999</c:v>
              </c:pt>
              <c:pt idx="1">
                <c:v>1.0249999999999999</c:v>
              </c:pt>
              <c:pt idx="2">
                <c:v>2</c:v>
              </c:pt>
              <c:pt idx="3">
                <c:v>2.9750000000000001</c:v>
              </c:pt>
              <c:pt idx="4">
                <c:v>2.9750000000000001</c:v>
              </c:pt>
            </c:numLit>
          </c:xVal>
          <c:yVal>
            <c:numLit>
              <c:formatCode>General</c:formatCode>
              <c:ptCount val="5"/>
              <c:pt idx="0">
                <c:v>1.1142857142857141</c:v>
              </c:pt>
              <c:pt idx="1">
                <c:v>1.1428571428571426</c:v>
              </c:pt>
              <c:pt idx="2">
                <c:v>1.1428571428571426</c:v>
              </c:pt>
              <c:pt idx="3">
                <c:v>1.1428571428571426</c:v>
              </c:pt>
              <c:pt idx="4">
                <c:v>1.114285714285714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A-F80A-4C29-BAB2-3F668D80C57A}"/>
            </c:ext>
          </c:extLst>
        </c:ser>
        <c:ser>
          <c:idx val="8"/>
          <c:order val="8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HS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B-F80A-4C29-BAB2-3F668D80C57A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AD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C-F80A-4C29-BAB2-3F668D80C57A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PD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D-F80A-4C29-BAB2-3F668D80C57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3"/>
              <c:pt idx="0">
                <c:v>1</c:v>
              </c:pt>
              <c:pt idx="1">
                <c:v>2</c:v>
              </c:pt>
              <c:pt idx="2">
                <c:v>3</c:v>
              </c:pt>
            </c:numLit>
          </c:xVal>
          <c:yVal>
            <c:numLit>
              <c:formatCode>General</c:formatCode>
              <c:ptCount val="3"/>
              <c:pt idx="0">
                <c:v>0.03</c:v>
              </c:pt>
              <c:pt idx="1">
                <c:v>0.03</c:v>
              </c:pt>
              <c:pt idx="2">
                <c:v>0.0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E-F80A-4C29-BAB2-3F668D80C5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2175103"/>
        <c:axId val="1462169695"/>
      </c:scatterChart>
      <c:valAx>
        <c:axId val="1462175103"/>
        <c:scaling>
          <c:orientation val="minMax"/>
          <c:max val="3.5"/>
          <c:min val="0.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2169695"/>
        <c:crosses val="autoZero"/>
        <c:crossBetween val="midCat"/>
      </c:valAx>
      <c:valAx>
        <c:axId val="1462169695"/>
        <c:scaling>
          <c:orientation val="minMax"/>
          <c:max val="1.1999999999999997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 smtClean="0"/>
                  <a:t>Ratio</a:t>
                </a:r>
                <a:endParaRPr lang="en-GB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2175103"/>
        <c:crossesAt val="0.5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(C18:2/C16:1)</a:t>
            </a:r>
          </a:p>
        </c:rich>
      </c:tx>
      <c:layout>
        <c:manualLayout>
          <c:xMode val="edge"/>
          <c:yMode val="edge"/>
          <c:x val="0.38964494021580637"/>
          <c:y val="4.36507936507936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xMode val="edge"/>
          <c:yMode val="edge"/>
          <c:x val="7.1589627685428217E-2"/>
          <c:y val="0.16406761654793151"/>
          <c:w val="0.89445975503062114"/>
          <c:h val="0.71688476440444926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8'!$A$1:$A$24</c:f>
              <c:numCache>
                <c:formatCode>General</c:formatCode>
                <c:ptCount val="24"/>
                <c:pt idx="0">
                  <c:v>1.2</c:v>
                </c:pt>
                <c:pt idx="1">
                  <c:v>0.8</c:v>
                </c:pt>
                <c:pt idx="2">
                  <c:v>1.1764705882352942</c:v>
                </c:pt>
                <c:pt idx="3">
                  <c:v>0.82352941176470584</c:v>
                </c:pt>
                <c:pt idx="4">
                  <c:v>1.1529411764705881</c:v>
                </c:pt>
                <c:pt idx="5">
                  <c:v>0.84705882352941175</c:v>
                </c:pt>
                <c:pt idx="6">
                  <c:v>1.1294117647058823</c:v>
                </c:pt>
                <c:pt idx="7">
                  <c:v>0.87058823529411766</c:v>
                </c:pt>
                <c:pt idx="8">
                  <c:v>1.1058823529411765</c:v>
                </c:pt>
                <c:pt idx="9">
                  <c:v>0.89411764705882357</c:v>
                </c:pt>
                <c:pt idx="10">
                  <c:v>1.0823529411764705</c:v>
                </c:pt>
                <c:pt idx="11">
                  <c:v>0.91764705882352937</c:v>
                </c:pt>
                <c:pt idx="12">
                  <c:v>1.0588235294117647</c:v>
                </c:pt>
                <c:pt idx="13">
                  <c:v>0.94117647058823528</c:v>
                </c:pt>
                <c:pt idx="14">
                  <c:v>1.0352941176470589</c:v>
                </c:pt>
                <c:pt idx="15">
                  <c:v>0.96470588235294119</c:v>
                </c:pt>
                <c:pt idx="16">
                  <c:v>1.0117647058823529</c:v>
                </c:pt>
                <c:pt idx="17">
                  <c:v>0.9882352941176471</c:v>
                </c:pt>
                <c:pt idx="18">
                  <c:v>1</c:v>
                </c:pt>
                <c:pt idx="19">
                  <c:v>0.96666666666666667</c:v>
                </c:pt>
                <c:pt idx="20">
                  <c:v>1.0333333333333334</c:v>
                </c:pt>
                <c:pt idx="21">
                  <c:v>1.0222222222222221</c:v>
                </c:pt>
                <c:pt idx="22">
                  <c:v>0.97777777777777775</c:v>
                </c:pt>
                <c:pt idx="23">
                  <c:v>1</c:v>
                </c:pt>
              </c:numCache>
            </c:numRef>
          </c:xVal>
          <c:yVal>
            <c:numRef>
              <c:f>'Kruskal-Wallis_HID18'!$B$1:$B$24</c:f>
              <c:numCache>
                <c:formatCode>General</c:formatCode>
                <c:ptCount val="24"/>
                <c:pt idx="0">
                  <c:v>4.9234686663626903E-2</c:v>
                </c:pt>
                <c:pt idx="1">
                  <c:v>5.1743029787165301E-2</c:v>
                </c:pt>
                <c:pt idx="2">
                  <c:v>7.0598113617844405E-2</c:v>
                </c:pt>
                <c:pt idx="3">
                  <c:v>9.558981253378461E-2</c:v>
                </c:pt>
                <c:pt idx="4">
                  <c:v>0.11079151893071049</c:v>
                </c:pt>
                <c:pt idx="5">
                  <c:v>0.11579793475258351</c:v>
                </c:pt>
                <c:pt idx="6">
                  <c:v>0.13351460086874875</c:v>
                </c:pt>
                <c:pt idx="7">
                  <c:v>0.13390516998261126</c:v>
                </c:pt>
                <c:pt idx="8">
                  <c:v>0.14264576166849335</c:v>
                </c:pt>
                <c:pt idx="9">
                  <c:v>0.14510651749366918</c:v>
                </c:pt>
                <c:pt idx="10">
                  <c:v>0.14732851001473915</c:v>
                </c:pt>
                <c:pt idx="11">
                  <c:v>0.16771517381521414</c:v>
                </c:pt>
                <c:pt idx="12">
                  <c:v>0.19033007248719705</c:v>
                </c:pt>
                <c:pt idx="13">
                  <c:v>0.24630796557078077</c:v>
                </c:pt>
                <c:pt idx="14">
                  <c:v>0.32433701899100759</c:v>
                </c:pt>
                <c:pt idx="15">
                  <c:v>0.32498841470984446</c:v>
                </c:pt>
                <c:pt idx="16">
                  <c:v>0.41776818701951485</c:v>
                </c:pt>
                <c:pt idx="17">
                  <c:v>0.43077079282893671</c:v>
                </c:pt>
                <c:pt idx="18">
                  <c:v>0.63577553623087701</c:v>
                </c:pt>
                <c:pt idx="19">
                  <c:v>0.78330091908546251</c:v>
                </c:pt>
                <c:pt idx="20">
                  <c:v>0.92742013382597865</c:v>
                </c:pt>
                <c:pt idx="21">
                  <c:v>1.1173735640428257</c:v>
                </c:pt>
                <c:pt idx="22">
                  <c:v>1.2357762136750088</c:v>
                </c:pt>
                <c:pt idx="23">
                  <c:v>4.08711044249652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2A4-4A30-B99B-33BFF071973E}"/>
            </c:ext>
          </c:extLst>
        </c:ser>
        <c:ser>
          <c:idx val="1"/>
          <c:order val="1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8'!$C$1:$C$20</c:f>
              <c:numCache>
                <c:formatCode>General</c:formatCode>
                <c:ptCount val="20"/>
                <c:pt idx="0">
                  <c:v>2</c:v>
                </c:pt>
                <c:pt idx="1">
                  <c:v>1.8</c:v>
                </c:pt>
                <c:pt idx="2">
                  <c:v>2.2000000000000002</c:v>
                </c:pt>
                <c:pt idx="3">
                  <c:v>1.84</c:v>
                </c:pt>
                <c:pt idx="4">
                  <c:v>2.16</c:v>
                </c:pt>
                <c:pt idx="5">
                  <c:v>1.88</c:v>
                </c:pt>
                <c:pt idx="6">
                  <c:v>2.12</c:v>
                </c:pt>
                <c:pt idx="7">
                  <c:v>1.92</c:v>
                </c:pt>
                <c:pt idx="8">
                  <c:v>2.08</c:v>
                </c:pt>
                <c:pt idx="9">
                  <c:v>1.96</c:v>
                </c:pt>
                <c:pt idx="10">
                  <c:v>2.04</c:v>
                </c:pt>
                <c:pt idx="11">
                  <c:v>2</c:v>
                </c:pt>
                <c:pt idx="12">
                  <c:v>1.9454545454545455</c:v>
                </c:pt>
                <c:pt idx="13">
                  <c:v>2.0545454545454547</c:v>
                </c:pt>
                <c:pt idx="14">
                  <c:v>2</c:v>
                </c:pt>
                <c:pt idx="15">
                  <c:v>2.0363636363636362</c:v>
                </c:pt>
                <c:pt idx="16">
                  <c:v>1.9636363636363636</c:v>
                </c:pt>
                <c:pt idx="17">
                  <c:v>2.0363636363636362</c:v>
                </c:pt>
                <c:pt idx="18">
                  <c:v>1.9636363636363636</c:v>
                </c:pt>
                <c:pt idx="19">
                  <c:v>2</c:v>
                </c:pt>
              </c:numCache>
            </c:numRef>
          </c:xVal>
          <c:yVal>
            <c:numRef>
              <c:f>'Kruskal-Wallis_HID18'!$D$1:$D$20</c:f>
              <c:numCache>
                <c:formatCode>General</c:formatCode>
                <c:ptCount val="20"/>
                <c:pt idx="0">
                  <c:v>6.00738407308858E-2</c:v>
                </c:pt>
                <c:pt idx="1">
                  <c:v>6.7978257709567766E-2</c:v>
                </c:pt>
                <c:pt idx="2">
                  <c:v>7.1090455348034223E-2</c:v>
                </c:pt>
                <c:pt idx="3">
                  <c:v>8.4607854552121331E-2</c:v>
                </c:pt>
                <c:pt idx="4">
                  <c:v>8.943440541343825E-2</c:v>
                </c:pt>
                <c:pt idx="5">
                  <c:v>9.4443849048298154E-2</c:v>
                </c:pt>
                <c:pt idx="6">
                  <c:v>9.554473972850043E-2</c:v>
                </c:pt>
                <c:pt idx="7">
                  <c:v>0.11383356333547574</c:v>
                </c:pt>
                <c:pt idx="8">
                  <c:v>0.11880831046282182</c:v>
                </c:pt>
                <c:pt idx="9">
                  <c:v>0.12083154154508878</c:v>
                </c:pt>
                <c:pt idx="10">
                  <c:v>0.18072242003316094</c:v>
                </c:pt>
                <c:pt idx="11">
                  <c:v>0.21512200378361826</c:v>
                </c:pt>
                <c:pt idx="12">
                  <c:v>0.27568494238751329</c:v>
                </c:pt>
                <c:pt idx="13">
                  <c:v>0.29999455831893324</c:v>
                </c:pt>
                <c:pt idx="14">
                  <c:v>0.40950757570120677</c:v>
                </c:pt>
                <c:pt idx="15">
                  <c:v>0.53369769716381965</c:v>
                </c:pt>
                <c:pt idx="16">
                  <c:v>0.62163864882631981</c:v>
                </c:pt>
                <c:pt idx="17">
                  <c:v>0.92957933897462452</c:v>
                </c:pt>
                <c:pt idx="18">
                  <c:v>1.0015288813315071</c:v>
                </c:pt>
                <c:pt idx="19">
                  <c:v>1.19733127726072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2A4-4A30-B99B-33BFF071973E}"/>
            </c:ext>
          </c:extLst>
        </c:ser>
        <c:ser>
          <c:idx val="2"/>
          <c:order val="2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8'!$E$1:$E$20</c:f>
              <c:numCache>
                <c:formatCode>General</c:formatCode>
                <c:ptCount val="20"/>
                <c:pt idx="0">
                  <c:v>3</c:v>
                </c:pt>
                <c:pt idx="1">
                  <c:v>2.8</c:v>
                </c:pt>
                <c:pt idx="2">
                  <c:v>3.2</c:v>
                </c:pt>
                <c:pt idx="3">
                  <c:v>2.8250000000000002</c:v>
                </c:pt>
                <c:pt idx="4">
                  <c:v>3.1749999999999998</c:v>
                </c:pt>
                <c:pt idx="5">
                  <c:v>2.85</c:v>
                </c:pt>
                <c:pt idx="6">
                  <c:v>3.15</c:v>
                </c:pt>
                <c:pt idx="7">
                  <c:v>2.875</c:v>
                </c:pt>
                <c:pt idx="8">
                  <c:v>3.125</c:v>
                </c:pt>
                <c:pt idx="9">
                  <c:v>2.9</c:v>
                </c:pt>
                <c:pt idx="10">
                  <c:v>3.1</c:v>
                </c:pt>
                <c:pt idx="11">
                  <c:v>2.9249999999999998</c:v>
                </c:pt>
                <c:pt idx="12">
                  <c:v>3.0750000000000002</c:v>
                </c:pt>
                <c:pt idx="13">
                  <c:v>2.95</c:v>
                </c:pt>
                <c:pt idx="14">
                  <c:v>3.05</c:v>
                </c:pt>
                <c:pt idx="15">
                  <c:v>2.9750000000000001</c:v>
                </c:pt>
                <c:pt idx="16">
                  <c:v>3.0249999999999999</c:v>
                </c:pt>
                <c:pt idx="17">
                  <c:v>3</c:v>
                </c:pt>
                <c:pt idx="18">
                  <c:v>3</c:v>
                </c:pt>
                <c:pt idx="19">
                  <c:v>3</c:v>
                </c:pt>
              </c:numCache>
            </c:numRef>
          </c:xVal>
          <c:yVal>
            <c:numRef>
              <c:f>'Kruskal-Wallis_HID18'!$F$1:$F$20</c:f>
              <c:numCache>
                <c:formatCode>General</c:formatCode>
                <c:ptCount val="20"/>
                <c:pt idx="0">
                  <c:v>2.5338650040940842E-2</c:v>
                </c:pt>
                <c:pt idx="1">
                  <c:v>2.6228164467038448E-2</c:v>
                </c:pt>
                <c:pt idx="2">
                  <c:v>3.9778087732392831E-2</c:v>
                </c:pt>
                <c:pt idx="3">
                  <c:v>4.0188075450532608E-2</c:v>
                </c:pt>
                <c:pt idx="4">
                  <c:v>4.6160043674348596E-2</c:v>
                </c:pt>
                <c:pt idx="5">
                  <c:v>5.485168411481716E-2</c:v>
                </c:pt>
                <c:pt idx="6">
                  <c:v>5.8156103955820451E-2</c:v>
                </c:pt>
                <c:pt idx="7">
                  <c:v>6.4672952862649194E-2</c:v>
                </c:pt>
                <c:pt idx="8">
                  <c:v>7.5750074350716554E-2</c:v>
                </c:pt>
                <c:pt idx="9">
                  <c:v>7.8082007461909866E-2</c:v>
                </c:pt>
                <c:pt idx="10">
                  <c:v>8.3085854362770703E-2</c:v>
                </c:pt>
                <c:pt idx="11">
                  <c:v>9.2090622932723215E-2</c:v>
                </c:pt>
                <c:pt idx="12">
                  <c:v>9.591641045717593E-2</c:v>
                </c:pt>
                <c:pt idx="13">
                  <c:v>0.11160533500414409</c:v>
                </c:pt>
                <c:pt idx="14">
                  <c:v>0.11923449111983574</c:v>
                </c:pt>
                <c:pt idx="15">
                  <c:v>0.12625877851981043</c:v>
                </c:pt>
                <c:pt idx="16">
                  <c:v>0.14769380512258851</c:v>
                </c:pt>
                <c:pt idx="17">
                  <c:v>0.30330581876990353</c:v>
                </c:pt>
                <c:pt idx="18">
                  <c:v>0.60209105905678229</c:v>
                </c:pt>
                <c:pt idx="19">
                  <c:v>1.501243076228535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2A4-4A30-B99B-33BFF071973E}"/>
            </c:ext>
          </c:extLst>
        </c:ser>
        <c:ser>
          <c:idx val="3"/>
          <c:order val="3"/>
          <c:tx>
            <c:v>Mea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2"/>
            <c:spPr>
              <a:solidFill>
                <a:srgbClr val="FFFF00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Lit>
              <c:formatCode>General</c:formatCode>
              <c:ptCount val="3"/>
              <c:pt idx="0">
                <c:v>1</c:v>
              </c:pt>
              <c:pt idx="1">
                <c:v>2</c:v>
              </c:pt>
              <c:pt idx="2">
                <c:v>3</c:v>
              </c:pt>
            </c:numLit>
          </c:xVal>
          <c:yVal>
            <c:numLit>
              <c:formatCode>General</c:formatCode>
              <c:ptCount val="3"/>
              <c:pt idx="0">
                <c:v>0.50355125379554799</c:v>
              </c:pt>
              <c:pt idx="1">
                <c:v>0.32907270808278311</c:v>
              </c:pt>
              <c:pt idx="2">
                <c:v>0.1845865547842718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D2A4-4A30-B99B-33BFF071973E}"/>
            </c:ext>
          </c:extLst>
        </c:ser>
        <c:ser>
          <c:idx val="4"/>
          <c:order val="4"/>
          <c:tx>
            <c:v>Median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dPt>
            <c:idx val="2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5-D2A4-4A30-B99B-33BFF071973E}"/>
              </c:ext>
            </c:extLst>
          </c:dPt>
          <c:dPt>
            <c:idx val="4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7-D2A4-4A30-B99B-33BFF071973E}"/>
              </c:ext>
            </c:extLst>
          </c:dPt>
          <c:xVal>
            <c:numLit>
              <c:formatCode>General</c:formatCode>
              <c:ptCount val="6"/>
              <c:pt idx="0">
                <c:v>0.75</c:v>
              </c:pt>
              <c:pt idx="1">
                <c:v>1.25</c:v>
              </c:pt>
              <c:pt idx="2">
                <c:v>1.75</c:v>
              </c:pt>
              <c:pt idx="3">
                <c:v>2.25</c:v>
              </c:pt>
              <c:pt idx="4">
                <c:v>2.75</c:v>
              </c:pt>
              <c:pt idx="5">
                <c:v>3.25</c:v>
              </c:pt>
            </c:numLit>
          </c:xVal>
          <c:yVal>
            <c:numLit>
              <c:formatCode>General</c:formatCode>
              <c:ptCount val="6"/>
              <c:pt idx="0">
                <c:v>0.1790226231512056</c:v>
              </c:pt>
              <c:pt idx="1">
                <c:v>0.1790226231512056</c:v>
              </c:pt>
              <c:pt idx="2">
                <c:v>0.15077698078912485</c:v>
              </c:pt>
              <c:pt idx="3">
                <c:v>0.15077698078912485</c:v>
              </c:pt>
              <c:pt idx="4">
                <c:v>8.0583930912340285E-2</c:v>
              </c:pt>
              <c:pt idx="5">
                <c:v>8.0583930912340285E-2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8-D2A4-4A30-B99B-33BFF071973E}"/>
            </c:ext>
          </c:extLst>
        </c:ser>
        <c:ser>
          <c:idx val="5"/>
          <c:order val="5"/>
          <c:tx>
            <c:v/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D2A4-4A30-B99B-33BFF071973E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A-D2A4-4A30-B99B-33BFF071973E}"/>
                </c:ext>
              </c:extLst>
            </c:dLbl>
            <c:dLbl>
              <c:idx val="2"/>
              <c:layout>
                <c:manualLayout>
                  <c:x val="-6.1898269660736853E-2"/>
                  <c:y val="-2.48909511311086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453</a:t>
                    </a:r>
                    <a:endParaRPr lang="en-US" dirty="0"/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D2A4-4A30-B99B-33BFF071973E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C-D2A4-4A30-B99B-33BFF071973E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D-D2A4-4A30-B99B-33BFF07197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1.0249999999999999</c:v>
              </c:pt>
              <c:pt idx="1">
                <c:v>1.0249999999999999</c:v>
              </c:pt>
              <c:pt idx="2">
                <c:v>1.5</c:v>
              </c:pt>
              <c:pt idx="3">
                <c:v>1.9750000000000001</c:v>
              </c:pt>
              <c:pt idx="4">
                <c:v>1.9750000000000001</c:v>
              </c:pt>
            </c:numLit>
          </c:xVal>
          <c:yVal>
            <c:numLit>
              <c:formatCode>General</c:formatCode>
              <c:ptCount val="5"/>
              <c:pt idx="0">
                <c:v>4.6285714285714281</c:v>
              </c:pt>
              <c:pt idx="1">
                <c:v>4.7571428571428562</c:v>
              </c:pt>
              <c:pt idx="2">
                <c:v>4.7571428571428562</c:v>
              </c:pt>
              <c:pt idx="3">
                <c:v>4.7571428571428562</c:v>
              </c:pt>
              <c:pt idx="4">
                <c:v>4.628571428571428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E-D2A4-4A30-B99B-33BFF071973E}"/>
            </c:ext>
          </c:extLst>
        </c:ser>
        <c:ser>
          <c:idx val="6"/>
          <c:order val="6"/>
          <c:tx>
            <c:v/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F-D2A4-4A30-B99B-33BFF071973E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0-D2A4-4A30-B99B-33BFF071973E}"/>
                </c:ext>
              </c:extLst>
            </c:dLbl>
            <c:dLbl>
              <c:idx val="2"/>
              <c:layout>
                <c:manualLayout>
                  <c:x val="-6.7276416836784286E-2"/>
                  <c:y val="-2.48909511311086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016</a:t>
                    </a:r>
                    <a:r>
                      <a:rPr lang="en-US" dirty="0"/>
                      <a:t>*</a:t>
                    </a:r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1-D2A4-4A30-B99B-33BFF071973E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2-D2A4-4A30-B99B-33BFF071973E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3-D2A4-4A30-B99B-33BFF07197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2.0249999999999999</c:v>
              </c:pt>
              <c:pt idx="1">
                <c:v>2.0249999999999999</c:v>
              </c:pt>
              <c:pt idx="2">
                <c:v>2.5</c:v>
              </c:pt>
              <c:pt idx="3">
                <c:v>2.9750000000000001</c:v>
              </c:pt>
              <c:pt idx="4">
                <c:v>2.9750000000000001</c:v>
              </c:pt>
            </c:numLit>
          </c:xVal>
          <c:yVal>
            <c:numLit>
              <c:formatCode>General</c:formatCode>
              <c:ptCount val="5"/>
              <c:pt idx="0">
                <c:v>4.6285714285714281</c:v>
              </c:pt>
              <c:pt idx="1">
                <c:v>4.7571428571428562</c:v>
              </c:pt>
              <c:pt idx="2">
                <c:v>4.7571428571428562</c:v>
              </c:pt>
              <c:pt idx="3">
                <c:v>4.7571428571428562</c:v>
              </c:pt>
              <c:pt idx="4">
                <c:v>4.628571428571428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4-D2A4-4A30-B99B-33BFF071973E}"/>
            </c:ext>
          </c:extLst>
        </c:ser>
        <c:ser>
          <c:idx val="7"/>
          <c:order val="7"/>
          <c:tx>
            <c:v/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5-D2A4-4A30-B99B-33BFF071973E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6-D2A4-4A30-B99B-33BFF071973E}"/>
                </c:ext>
              </c:extLst>
            </c:dLbl>
            <c:dLbl>
              <c:idx val="2"/>
              <c:layout>
                <c:manualLayout>
                  <c:x val="-6.7276416836784286E-2"/>
                  <c:y val="-2.48909511311086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001</a:t>
                    </a:r>
                    <a:r>
                      <a:rPr lang="en-US" dirty="0"/>
                      <a:t>*</a:t>
                    </a:r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7-D2A4-4A30-B99B-33BFF071973E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8-D2A4-4A30-B99B-33BFF071973E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9-D2A4-4A30-B99B-33BFF07197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1.0249999999999999</c:v>
              </c:pt>
              <c:pt idx="1">
                <c:v>1.0249999999999999</c:v>
              </c:pt>
              <c:pt idx="2">
                <c:v>2</c:v>
              </c:pt>
              <c:pt idx="3">
                <c:v>2.9750000000000001</c:v>
              </c:pt>
              <c:pt idx="4">
                <c:v>2.9750000000000001</c:v>
              </c:pt>
            </c:numLit>
          </c:xVal>
          <c:yVal>
            <c:numLit>
              <c:formatCode>General</c:formatCode>
              <c:ptCount val="5"/>
              <c:pt idx="0">
                <c:v>5.0142857142857133</c:v>
              </c:pt>
              <c:pt idx="1">
                <c:v>5.1428571428571423</c:v>
              </c:pt>
              <c:pt idx="2">
                <c:v>5.1428571428571423</c:v>
              </c:pt>
              <c:pt idx="3">
                <c:v>5.1428571428571423</c:v>
              </c:pt>
              <c:pt idx="4">
                <c:v>5.014285714285713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A-D2A4-4A30-B99B-33BFF071973E}"/>
            </c:ext>
          </c:extLst>
        </c:ser>
        <c:ser>
          <c:idx val="8"/>
          <c:order val="8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HS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B-D2A4-4A30-B99B-33BFF071973E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AD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C-D2A4-4A30-B99B-33BFF071973E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PD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D-D2A4-4A30-B99B-33BFF07197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3"/>
              <c:pt idx="0">
                <c:v>1</c:v>
              </c:pt>
              <c:pt idx="1">
                <c:v>2</c:v>
              </c:pt>
              <c:pt idx="2">
                <c:v>3</c:v>
              </c:pt>
            </c:numLit>
          </c:xVal>
          <c:yVal>
            <c:numLit>
              <c:formatCode>General</c:formatCode>
              <c:ptCount val="3"/>
              <c:pt idx="0">
                <c:v>0.13500000000000001</c:v>
              </c:pt>
              <c:pt idx="1">
                <c:v>0.13500000000000001</c:v>
              </c:pt>
              <c:pt idx="2">
                <c:v>0.1350000000000000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E-D2A4-4A30-B99B-33BFF07197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2168863"/>
        <c:axId val="1462167199"/>
      </c:scatterChart>
      <c:valAx>
        <c:axId val="1462168863"/>
        <c:scaling>
          <c:orientation val="minMax"/>
          <c:max val="3.5"/>
          <c:min val="0.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2167199"/>
        <c:crosses val="autoZero"/>
        <c:crossBetween val="midCat"/>
      </c:valAx>
      <c:valAx>
        <c:axId val="1462167199"/>
        <c:scaling>
          <c:orientation val="minMax"/>
          <c:max val="6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 smtClean="0"/>
                  <a:t>Ratio</a:t>
                </a:r>
                <a:endParaRPr lang="en-GB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2168863"/>
        <c:crossesAt val="0.5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</a:defRPr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(C24:0/C18:0)</a:t>
            </a:r>
          </a:p>
        </c:rich>
      </c:tx>
      <c:layout>
        <c:manualLayout>
          <c:xMode val="edge"/>
          <c:yMode val="edge"/>
          <c:x val="0.40816345873432486"/>
          <c:y val="3.174603174603174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xMode val="edge"/>
          <c:yMode val="edge"/>
          <c:x val="7.1589627685428217E-2"/>
          <c:y val="0.16406761654793151"/>
          <c:w val="0.89445975503062114"/>
          <c:h val="0.79624984376952868"/>
        </c:manualLayout>
      </c:layout>
      <c:scatterChart>
        <c:scatterStyle val="lineMarker"/>
        <c:varyColors val="0"/>
        <c:ser>
          <c:idx val="0"/>
          <c:order val="0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9'!$A$1:$A$24</c:f>
              <c:numCache>
                <c:formatCode>General</c:formatCode>
                <c:ptCount val="24"/>
                <c:pt idx="0">
                  <c:v>1.2</c:v>
                </c:pt>
                <c:pt idx="1">
                  <c:v>0.8</c:v>
                </c:pt>
                <c:pt idx="2">
                  <c:v>1.1555555555555557</c:v>
                </c:pt>
                <c:pt idx="3">
                  <c:v>0.84444444444444444</c:v>
                </c:pt>
                <c:pt idx="4">
                  <c:v>1.1111111111111112</c:v>
                </c:pt>
                <c:pt idx="5">
                  <c:v>0.88888888888888884</c:v>
                </c:pt>
                <c:pt idx="6">
                  <c:v>1.0666666666666667</c:v>
                </c:pt>
                <c:pt idx="7">
                  <c:v>0.93333333333333335</c:v>
                </c:pt>
                <c:pt idx="8">
                  <c:v>1.0222222222222221</c:v>
                </c:pt>
                <c:pt idx="9">
                  <c:v>0.97777777777777775</c:v>
                </c:pt>
                <c:pt idx="10">
                  <c:v>1.08</c:v>
                </c:pt>
                <c:pt idx="11">
                  <c:v>0.92</c:v>
                </c:pt>
                <c:pt idx="12">
                  <c:v>1.0266666666666666</c:v>
                </c:pt>
                <c:pt idx="13">
                  <c:v>0.97333333333333338</c:v>
                </c:pt>
                <c:pt idx="14">
                  <c:v>1.08</c:v>
                </c:pt>
                <c:pt idx="15">
                  <c:v>0.92</c:v>
                </c:pt>
                <c:pt idx="16">
                  <c:v>1.0266666666666666</c:v>
                </c:pt>
                <c:pt idx="17">
                  <c:v>0.97333333333333338</c:v>
                </c:pt>
                <c:pt idx="18">
                  <c:v>1.04</c:v>
                </c:pt>
                <c:pt idx="19">
                  <c:v>0.96</c:v>
                </c:pt>
                <c:pt idx="20">
                  <c:v>1</c:v>
                </c:pt>
                <c:pt idx="21">
                  <c:v>1.04</c:v>
                </c:pt>
                <c:pt idx="22">
                  <c:v>0.96</c:v>
                </c:pt>
                <c:pt idx="23">
                  <c:v>1</c:v>
                </c:pt>
              </c:numCache>
            </c:numRef>
          </c:xVal>
          <c:yVal>
            <c:numRef>
              <c:f>'Kruskal-Wallis_HID19'!$B$1:$B$24</c:f>
              <c:numCache>
                <c:formatCode>General</c:formatCode>
                <c:ptCount val="24"/>
                <c:pt idx="0">
                  <c:v>1.1688482711390473E-2</c:v>
                </c:pt>
                <c:pt idx="1">
                  <c:v>1.3084982807536356E-2</c:v>
                </c:pt>
                <c:pt idx="2">
                  <c:v>1.5963547695907663E-2</c:v>
                </c:pt>
                <c:pt idx="3">
                  <c:v>1.7229061758122124E-2</c:v>
                </c:pt>
                <c:pt idx="4">
                  <c:v>1.7630431190930964E-2</c:v>
                </c:pt>
                <c:pt idx="5">
                  <c:v>2.2216175926379728E-2</c:v>
                </c:pt>
                <c:pt idx="6">
                  <c:v>2.7368756413784494E-2</c:v>
                </c:pt>
                <c:pt idx="7">
                  <c:v>4.1714156875485187E-2</c:v>
                </c:pt>
                <c:pt idx="8">
                  <c:v>4.8560600090906153E-2</c:v>
                </c:pt>
                <c:pt idx="9">
                  <c:v>4.9217040503086298E-2</c:v>
                </c:pt>
                <c:pt idx="10">
                  <c:v>5.514670264221154E-2</c:v>
                </c:pt>
                <c:pt idx="11">
                  <c:v>5.7552659341342419E-2</c:v>
                </c:pt>
                <c:pt idx="12">
                  <c:v>6.4237968055839714E-2</c:v>
                </c:pt>
                <c:pt idx="13">
                  <c:v>8.0939363765887146E-2</c:v>
                </c:pt>
                <c:pt idx="14">
                  <c:v>9.8832792083203197E-2</c:v>
                </c:pt>
                <c:pt idx="15">
                  <c:v>0.10226477636453135</c:v>
                </c:pt>
                <c:pt idx="16">
                  <c:v>0.10745069663412465</c:v>
                </c:pt>
                <c:pt idx="17">
                  <c:v>0.12514124492830658</c:v>
                </c:pt>
                <c:pt idx="18">
                  <c:v>0.16290693913659518</c:v>
                </c:pt>
                <c:pt idx="19">
                  <c:v>0.16388512482900622</c:v>
                </c:pt>
                <c:pt idx="20">
                  <c:v>0.17792711046168944</c:v>
                </c:pt>
                <c:pt idx="21">
                  <c:v>0.2057808388136381</c:v>
                </c:pt>
                <c:pt idx="22">
                  <c:v>0.20803134595738035</c:v>
                </c:pt>
                <c:pt idx="23">
                  <c:v>0.320713491506639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B5C-40A0-B3FA-6E042D6707BC}"/>
            </c:ext>
          </c:extLst>
        </c:ser>
        <c:ser>
          <c:idx val="1"/>
          <c:order val="1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9'!$C$1:$C$20</c:f>
              <c:numCache>
                <c:formatCode>General</c:formatCode>
                <c:ptCount val="20"/>
                <c:pt idx="0">
                  <c:v>2</c:v>
                </c:pt>
                <c:pt idx="1">
                  <c:v>1.9</c:v>
                </c:pt>
                <c:pt idx="2">
                  <c:v>2.1</c:v>
                </c:pt>
                <c:pt idx="3">
                  <c:v>2.2000000000000002</c:v>
                </c:pt>
                <c:pt idx="4">
                  <c:v>1.8</c:v>
                </c:pt>
                <c:pt idx="5">
                  <c:v>2.12</c:v>
                </c:pt>
                <c:pt idx="6">
                  <c:v>1.88</c:v>
                </c:pt>
                <c:pt idx="7">
                  <c:v>2.04</c:v>
                </c:pt>
                <c:pt idx="8">
                  <c:v>1.96</c:v>
                </c:pt>
                <c:pt idx="9">
                  <c:v>2.2000000000000002</c:v>
                </c:pt>
                <c:pt idx="10">
                  <c:v>1.8</c:v>
                </c:pt>
                <c:pt idx="11">
                  <c:v>2.12</c:v>
                </c:pt>
                <c:pt idx="12">
                  <c:v>1.88</c:v>
                </c:pt>
                <c:pt idx="13">
                  <c:v>2.04</c:v>
                </c:pt>
                <c:pt idx="14">
                  <c:v>1.96</c:v>
                </c:pt>
                <c:pt idx="15">
                  <c:v>2.0666666666666669</c:v>
                </c:pt>
                <c:pt idx="16">
                  <c:v>1.9333333333333333</c:v>
                </c:pt>
                <c:pt idx="17">
                  <c:v>2.0666666666666669</c:v>
                </c:pt>
                <c:pt idx="18">
                  <c:v>1.9333333333333333</c:v>
                </c:pt>
                <c:pt idx="19">
                  <c:v>2</c:v>
                </c:pt>
              </c:numCache>
            </c:numRef>
          </c:xVal>
          <c:yVal>
            <c:numRef>
              <c:f>'Kruskal-Wallis_HID19'!$D$1:$D$20</c:f>
              <c:numCache>
                <c:formatCode>General</c:formatCode>
                <c:ptCount val="20"/>
                <c:pt idx="0">
                  <c:v>1.4861871310128991E-2</c:v>
                </c:pt>
                <c:pt idx="1">
                  <c:v>4.0227960964762971E-2</c:v>
                </c:pt>
                <c:pt idx="2">
                  <c:v>4.0911321657879439E-2</c:v>
                </c:pt>
                <c:pt idx="3">
                  <c:v>4.7606147178635053E-2</c:v>
                </c:pt>
                <c:pt idx="4">
                  <c:v>5.034063571698922E-2</c:v>
                </c:pt>
                <c:pt idx="5">
                  <c:v>5.5325928516233407E-2</c:v>
                </c:pt>
                <c:pt idx="6">
                  <c:v>6.0178414899014099E-2</c:v>
                </c:pt>
                <c:pt idx="7">
                  <c:v>6.3704263225964453E-2</c:v>
                </c:pt>
                <c:pt idx="8">
                  <c:v>6.4494613721150687E-2</c:v>
                </c:pt>
                <c:pt idx="9">
                  <c:v>7.9512904515315883E-2</c:v>
                </c:pt>
                <c:pt idx="10">
                  <c:v>8.2422605461835025E-2</c:v>
                </c:pt>
                <c:pt idx="11">
                  <c:v>9.0525486615472731E-2</c:v>
                </c:pt>
                <c:pt idx="12">
                  <c:v>9.3370730111558456E-2</c:v>
                </c:pt>
                <c:pt idx="13">
                  <c:v>9.5113358825962502E-2</c:v>
                </c:pt>
                <c:pt idx="14">
                  <c:v>9.7313967633008036E-2</c:v>
                </c:pt>
                <c:pt idx="15">
                  <c:v>0.12831711987068489</c:v>
                </c:pt>
                <c:pt idx="16">
                  <c:v>0.13306150528025226</c:v>
                </c:pt>
                <c:pt idx="17">
                  <c:v>0.16484510227090815</c:v>
                </c:pt>
                <c:pt idx="18">
                  <c:v>0.16953644691519948</c:v>
                </c:pt>
                <c:pt idx="19">
                  <c:v>0.266789860784000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B5C-40A0-B3FA-6E042D6707BC}"/>
            </c:ext>
          </c:extLst>
        </c:ser>
        <c:ser>
          <c:idx val="2"/>
          <c:order val="2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2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Kruskal-Wallis_HID19'!$E$1:$E$20</c:f>
              <c:numCache>
                <c:formatCode>General</c:formatCode>
                <c:ptCount val="20"/>
                <c:pt idx="0">
                  <c:v>3</c:v>
                </c:pt>
                <c:pt idx="1">
                  <c:v>2.8</c:v>
                </c:pt>
                <c:pt idx="2">
                  <c:v>3.2</c:v>
                </c:pt>
                <c:pt idx="3">
                  <c:v>2.9</c:v>
                </c:pt>
                <c:pt idx="4">
                  <c:v>3.1</c:v>
                </c:pt>
                <c:pt idx="5">
                  <c:v>3</c:v>
                </c:pt>
                <c:pt idx="6">
                  <c:v>2.88</c:v>
                </c:pt>
                <c:pt idx="7">
                  <c:v>3.12</c:v>
                </c:pt>
                <c:pt idx="8">
                  <c:v>3.08</c:v>
                </c:pt>
                <c:pt idx="9">
                  <c:v>2.92</c:v>
                </c:pt>
                <c:pt idx="10">
                  <c:v>3</c:v>
                </c:pt>
                <c:pt idx="11">
                  <c:v>2.8</c:v>
                </c:pt>
                <c:pt idx="12">
                  <c:v>3.2</c:v>
                </c:pt>
                <c:pt idx="13">
                  <c:v>2.9</c:v>
                </c:pt>
                <c:pt idx="14">
                  <c:v>3.1</c:v>
                </c:pt>
                <c:pt idx="15">
                  <c:v>3</c:v>
                </c:pt>
                <c:pt idx="16">
                  <c:v>3</c:v>
                </c:pt>
                <c:pt idx="17">
                  <c:v>2.88</c:v>
                </c:pt>
                <c:pt idx="18">
                  <c:v>3.12</c:v>
                </c:pt>
                <c:pt idx="19">
                  <c:v>3</c:v>
                </c:pt>
              </c:numCache>
            </c:numRef>
          </c:xVal>
          <c:yVal>
            <c:numRef>
              <c:f>'Kruskal-Wallis_HID19'!$F$1:$F$20</c:f>
              <c:numCache>
                <c:formatCode>General</c:formatCode>
                <c:ptCount val="20"/>
                <c:pt idx="0">
                  <c:v>1.3576181659780067E-2</c:v>
                </c:pt>
                <c:pt idx="1">
                  <c:v>2.1828925606324625E-2</c:v>
                </c:pt>
                <c:pt idx="2">
                  <c:v>3.4345258283598273E-2</c:v>
                </c:pt>
                <c:pt idx="3">
                  <c:v>4.6748864067027711E-2</c:v>
                </c:pt>
                <c:pt idx="4">
                  <c:v>4.7173334788557321E-2</c:v>
                </c:pt>
                <c:pt idx="5">
                  <c:v>7.0929633332167077E-2</c:v>
                </c:pt>
                <c:pt idx="6">
                  <c:v>7.1994406641464365E-2</c:v>
                </c:pt>
                <c:pt idx="7">
                  <c:v>7.4891766309446869E-2</c:v>
                </c:pt>
                <c:pt idx="8">
                  <c:v>0.1128437188949553</c:v>
                </c:pt>
                <c:pt idx="9">
                  <c:v>0.12977335771826273</c:v>
                </c:pt>
                <c:pt idx="10">
                  <c:v>0.15931109513588868</c:v>
                </c:pt>
                <c:pt idx="11">
                  <c:v>0.17981819662946158</c:v>
                </c:pt>
                <c:pt idx="12">
                  <c:v>0.18957149904450951</c:v>
                </c:pt>
                <c:pt idx="13">
                  <c:v>0.19044613245119812</c:v>
                </c:pt>
                <c:pt idx="14">
                  <c:v>0.19439241518244049</c:v>
                </c:pt>
                <c:pt idx="15">
                  <c:v>0.24002035770221683</c:v>
                </c:pt>
                <c:pt idx="16">
                  <c:v>0.27737742662872344</c:v>
                </c:pt>
                <c:pt idx="17">
                  <c:v>0.28734415353596116</c:v>
                </c:pt>
                <c:pt idx="18">
                  <c:v>0.28768039046291533</c:v>
                </c:pt>
                <c:pt idx="19">
                  <c:v>0.394011776508110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B5C-40A0-B3FA-6E042D6707BC}"/>
            </c:ext>
          </c:extLst>
        </c:ser>
        <c:ser>
          <c:idx val="3"/>
          <c:order val="3"/>
          <c:tx>
            <c:v>Mea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2"/>
            <c:spPr>
              <a:solidFill>
                <a:srgbClr val="FF66CC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12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1-5B5C-40A0-B3FA-6E042D6707BC}"/>
              </c:ext>
            </c:extLst>
          </c:dPt>
          <c:dPt>
            <c:idx val="1"/>
            <c:marker>
              <c:symbol val="circle"/>
              <c:size val="12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F-5B5C-40A0-B3FA-6E042D6707BC}"/>
              </c:ext>
            </c:extLst>
          </c:dPt>
          <c:dPt>
            <c:idx val="2"/>
            <c:marker>
              <c:symbol val="circle"/>
              <c:size val="12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0-5B5C-40A0-B3FA-6E042D6707BC}"/>
              </c:ext>
            </c:extLst>
          </c:dPt>
          <c:xVal>
            <c:numLit>
              <c:formatCode>General</c:formatCode>
              <c:ptCount val="3"/>
              <c:pt idx="0">
                <c:v>1</c:v>
              </c:pt>
              <c:pt idx="1">
                <c:v>2</c:v>
              </c:pt>
              <c:pt idx="2">
                <c:v>3</c:v>
              </c:pt>
            </c:numLit>
          </c:xVal>
          <c:yVal>
            <c:numLit>
              <c:formatCode>General</c:formatCode>
              <c:ptCount val="3"/>
              <c:pt idx="0">
                <c:v>9.1478512103913542E-2</c:v>
              </c:pt>
              <c:pt idx="1">
                <c:v>9.1923012273747801E-2</c:v>
              </c:pt>
              <c:pt idx="2">
                <c:v>0.1512039445291505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5B5C-40A0-B3FA-6E042D6707BC}"/>
            </c:ext>
          </c:extLst>
        </c:ser>
        <c:ser>
          <c:idx val="4"/>
          <c:order val="4"/>
          <c:tx>
            <c:v>Median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dPt>
            <c:idx val="2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5-5B5C-40A0-B3FA-6E042D6707BC}"/>
              </c:ext>
            </c:extLst>
          </c:dPt>
          <c:dPt>
            <c:idx val="4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7-5B5C-40A0-B3FA-6E042D6707BC}"/>
              </c:ext>
            </c:extLst>
          </c:dPt>
          <c:xVal>
            <c:numLit>
              <c:formatCode>General</c:formatCode>
              <c:ptCount val="6"/>
              <c:pt idx="0">
                <c:v>0.75</c:v>
              </c:pt>
              <c:pt idx="1">
                <c:v>1.25</c:v>
              </c:pt>
              <c:pt idx="2">
                <c:v>1.75</c:v>
              </c:pt>
              <c:pt idx="3">
                <c:v>2.25</c:v>
              </c:pt>
              <c:pt idx="4">
                <c:v>2.75</c:v>
              </c:pt>
              <c:pt idx="5">
                <c:v>3.25</c:v>
              </c:pt>
            </c:numLit>
          </c:xVal>
          <c:yVal>
            <c:numLit>
              <c:formatCode>General</c:formatCode>
              <c:ptCount val="6"/>
              <c:pt idx="0">
                <c:v>6.0895313698591066E-2</c:v>
              </c:pt>
              <c:pt idx="1">
                <c:v>6.0895313698591066E-2</c:v>
              </c:pt>
              <c:pt idx="2">
                <c:v>8.0967754988575447E-2</c:v>
              </c:pt>
              <c:pt idx="3">
                <c:v>8.0967754988575447E-2</c:v>
              </c:pt>
              <c:pt idx="4">
                <c:v>0.1445422264270757</c:v>
              </c:pt>
              <c:pt idx="5">
                <c:v>0.1445422264270757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8-5B5C-40A0-B3FA-6E042D6707BC}"/>
            </c:ext>
          </c:extLst>
        </c:ser>
        <c:ser>
          <c:idx val="5"/>
          <c:order val="5"/>
          <c:tx>
            <c:v/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5B5C-40A0-B3FA-6E042D6707BC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A-5B5C-40A0-B3FA-6E042D6707BC}"/>
                </c:ext>
              </c:extLst>
            </c:dLbl>
            <c:dLbl>
              <c:idx val="2"/>
              <c:layout>
                <c:manualLayout>
                  <c:x val="-6.1898269660736853E-2"/>
                  <c:y val="-2.48909511311086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630</a:t>
                    </a:r>
                    <a:endParaRPr lang="en-US" dirty="0"/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5B5C-40A0-B3FA-6E042D6707BC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C-5B5C-40A0-B3FA-6E042D6707BC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D-5B5C-40A0-B3FA-6E042D6707B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1.0249999999999999</c:v>
              </c:pt>
              <c:pt idx="1">
                <c:v>1.0249999999999999</c:v>
              </c:pt>
              <c:pt idx="2">
                <c:v>1.5</c:v>
              </c:pt>
              <c:pt idx="3">
                <c:v>1.9750000000000001</c:v>
              </c:pt>
              <c:pt idx="4">
                <c:v>1.9750000000000001</c:v>
              </c:pt>
            </c:numLit>
          </c:xVal>
          <c:yVal>
            <c:numLit>
              <c:formatCode>General</c:formatCode>
              <c:ptCount val="5"/>
              <c:pt idx="0">
                <c:v>0.41142857142857148</c:v>
              </c:pt>
              <c:pt idx="1">
                <c:v>0.42285714285714293</c:v>
              </c:pt>
              <c:pt idx="2">
                <c:v>0.42285714285714293</c:v>
              </c:pt>
              <c:pt idx="3">
                <c:v>0.42285714285714293</c:v>
              </c:pt>
              <c:pt idx="4">
                <c:v>0.41142857142857148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E-5B5C-40A0-B3FA-6E042D6707BC}"/>
            </c:ext>
          </c:extLst>
        </c:ser>
        <c:ser>
          <c:idx val="6"/>
          <c:order val="6"/>
          <c:tx>
            <c:v/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F-5B5C-40A0-B3FA-6E042D6707BC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0-5B5C-40A0-B3FA-6E042D6707BC}"/>
                </c:ext>
              </c:extLst>
            </c:dLbl>
            <c:dLbl>
              <c:idx val="2"/>
              <c:layout>
                <c:manualLayout>
                  <c:x val="-6.1898269660736853E-2"/>
                  <c:y val="-2.48909511311086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140</a:t>
                    </a:r>
                    <a:endParaRPr lang="en-US" dirty="0"/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1-5B5C-40A0-B3FA-6E042D6707BC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2-5B5C-40A0-B3FA-6E042D6707BC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3-5B5C-40A0-B3FA-6E042D6707B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2.0249999999999999</c:v>
              </c:pt>
              <c:pt idx="1">
                <c:v>2.0249999999999999</c:v>
              </c:pt>
              <c:pt idx="2">
                <c:v>2.5</c:v>
              </c:pt>
              <c:pt idx="3">
                <c:v>2.9750000000000001</c:v>
              </c:pt>
              <c:pt idx="4">
                <c:v>2.9750000000000001</c:v>
              </c:pt>
            </c:numLit>
          </c:xVal>
          <c:yVal>
            <c:numLit>
              <c:formatCode>General</c:formatCode>
              <c:ptCount val="5"/>
              <c:pt idx="0">
                <c:v>0.41142857142857148</c:v>
              </c:pt>
              <c:pt idx="1">
                <c:v>0.42285714285714293</c:v>
              </c:pt>
              <c:pt idx="2">
                <c:v>0.42285714285714293</c:v>
              </c:pt>
              <c:pt idx="3">
                <c:v>0.42285714285714293</c:v>
              </c:pt>
              <c:pt idx="4">
                <c:v>0.41142857142857148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4-5B5C-40A0-B3FA-6E042D6707BC}"/>
            </c:ext>
          </c:extLst>
        </c:ser>
        <c:ser>
          <c:idx val="7"/>
          <c:order val="7"/>
          <c:tx>
            <c:v/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5-5B5C-40A0-B3FA-6E042D6707BC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6-5B5C-40A0-B3FA-6E042D6707BC}"/>
                </c:ext>
              </c:extLst>
            </c:dLbl>
            <c:dLbl>
              <c:idx val="2"/>
              <c:layout>
                <c:manualLayout>
                  <c:x val="-6.1898269660736853E-2"/>
                  <c:y val="-2.48909511311086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=.043</a:t>
                    </a:r>
                    <a:endParaRPr lang="en-US" dirty="0"/>
                  </a:p>
                </c:rich>
              </c:tx>
              <c:dLblPos val="r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7-5B5C-40A0-B3FA-6E042D6707BC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8-5B5C-40A0-B3FA-6E042D6707BC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/>
                      <a:t> </a:t>
                    </a:r>
                  </a:p>
                </c:rich>
              </c:tx>
              <c:dLblPos val="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9-5B5C-40A0-B3FA-6E042D6707B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5"/>
              <c:pt idx="0">
                <c:v>1.0249999999999999</c:v>
              </c:pt>
              <c:pt idx="1">
                <c:v>1.0249999999999999</c:v>
              </c:pt>
              <c:pt idx="2">
                <c:v>2</c:v>
              </c:pt>
              <c:pt idx="3">
                <c:v>2.9750000000000001</c:v>
              </c:pt>
              <c:pt idx="4">
                <c:v>2.9750000000000001</c:v>
              </c:pt>
            </c:numLit>
          </c:xVal>
          <c:yVal>
            <c:numLit>
              <c:formatCode>General</c:formatCode>
              <c:ptCount val="5"/>
              <c:pt idx="0">
                <c:v>0.44571428571428579</c:v>
              </c:pt>
              <c:pt idx="1">
                <c:v>0.45714285714285724</c:v>
              </c:pt>
              <c:pt idx="2">
                <c:v>0.45714285714285724</c:v>
              </c:pt>
              <c:pt idx="3">
                <c:v>0.45714285714285724</c:v>
              </c:pt>
              <c:pt idx="4">
                <c:v>0.44571428571428579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A-5B5C-40A0-B3FA-6E042D6707BC}"/>
            </c:ext>
          </c:extLst>
        </c:ser>
        <c:ser>
          <c:idx val="8"/>
          <c:order val="8"/>
          <c:tx>
            <c:v/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HS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B-5B5C-40A0-B3FA-6E042D6707BC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AD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C-5B5C-40A0-B3FA-6E042D6707BC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dirty="0" smtClean="0"/>
                      <a:t>PD</a:t>
                    </a:r>
                    <a:endParaRPr lang="en-US" dirty="0"/>
                  </a:p>
                </c:rich>
              </c:tx>
              <c:dLblPos val="b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D-5B5C-40A0-B3FA-6E042D6707B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"/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Lit>
              <c:formatCode>General</c:formatCode>
              <c:ptCount val="3"/>
              <c:pt idx="0">
                <c:v>1</c:v>
              </c:pt>
              <c:pt idx="1">
                <c:v>2</c:v>
              </c:pt>
              <c:pt idx="2">
                <c:v>3</c:v>
              </c:pt>
            </c:numLit>
          </c:xVal>
          <c:yVal>
            <c:numLit>
              <c:formatCode>General</c:formatCode>
              <c:ptCount val="3"/>
              <c:pt idx="0">
                <c:v>1.2E-2</c:v>
              </c:pt>
              <c:pt idx="1">
                <c:v>1.2E-2</c:v>
              </c:pt>
              <c:pt idx="2">
                <c:v>1.2E-2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1E-5B5C-40A0-B3FA-6E042D6707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2168863"/>
        <c:axId val="1462165951"/>
      </c:scatterChart>
      <c:valAx>
        <c:axId val="1462168863"/>
        <c:scaling>
          <c:orientation val="minMax"/>
          <c:max val="3.5"/>
          <c:min val="0.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2165951"/>
        <c:crosses val="autoZero"/>
        <c:crossBetween val="midCat"/>
      </c:valAx>
      <c:valAx>
        <c:axId val="1462165951"/>
        <c:scaling>
          <c:orientation val="minMax"/>
          <c:max val="0.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 smtClean="0"/>
                  <a:t>Ratio</a:t>
                </a:r>
                <a:endParaRPr lang="en-GB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2168863"/>
        <c:crossesAt val="0.5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0772</cdr:x>
      <cdr:y>0.93749</cdr:y>
    </cdr:from>
    <cdr:to>
      <cdr:x>1</cdr:x>
      <cdr:y>1</cdr:y>
    </cdr:to>
    <cdr:sp macro="" textlink="">
      <cdr:nvSpPr>
        <cdr:cNvPr id="2" name="CasellaDiTesto 1"/>
        <cdr:cNvSpPr txBox="1"/>
      </cdr:nvSpPr>
      <cdr:spPr>
        <a:xfrm xmlns:a="http://schemas.openxmlformats.org/drawingml/2006/main">
          <a:off x="2089166" y="3004824"/>
          <a:ext cx="2025634" cy="20005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horz" rtlCol="0">
          <a:spAutoFit/>
        </a:bodyPr>
        <a:lstStyle xmlns:a="http://schemas.openxmlformats.org/drawingml/2006/main"/>
        <a:p xmlns:a="http://schemas.openxmlformats.org/drawingml/2006/main">
          <a:pPr algn="r"/>
          <a:r>
            <a:rPr lang="en-GB" sz="700" dirty="0">
              <a:latin typeface="Arial" panose="020B0604020202020204" pitchFamily="34" charset="0"/>
            </a:rPr>
            <a:t>*: significant at level </a:t>
          </a:r>
          <a:r>
            <a:rPr lang="en-GB" sz="700" dirty="0" smtClean="0">
              <a:latin typeface="Arial" panose="020B0604020202020204" pitchFamily="34" charset="0"/>
            </a:rPr>
            <a:t>alpha=.05</a:t>
          </a:r>
          <a:endParaRPr lang="en-GB" sz="700" dirty="0">
            <a:latin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50772</cdr:x>
      <cdr:y>0.93749</cdr:y>
    </cdr:from>
    <cdr:to>
      <cdr:x>1</cdr:x>
      <cdr:y>1</cdr:y>
    </cdr:to>
    <cdr:sp macro="" textlink="">
      <cdr:nvSpPr>
        <cdr:cNvPr id="2" name="CasellaDiTesto 1"/>
        <cdr:cNvSpPr txBox="1"/>
      </cdr:nvSpPr>
      <cdr:spPr>
        <a:xfrm xmlns:a="http://schemas.openxmlformats.org/drawingml/2006/main">
          <a:off x="2089166" y="3004824"/>
          <a:ext cx="2025634" cy="20005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horz" rtlCol="0">
          <a:spAutoFit/>
        </a:bodyPr>
        <a:lstStyle xmlns:a="http://schemas.openxmlformats.org/drawingml/2006/main"/>
        <a:p xmlns:a="http://schemas.openxmlformats.org/drawingml/2006/main">
          <a:pPr algn="r"/>
          <a:r>
            <a:rPr lang="en-GB" sz="700" dirty="0">
              <a:latin typeface="Arial" panose="020B0604020202020204" pitchFamily="34" charset="0"/>
            </a:rPr>
            <a:t>*: significant at level </a:t>
          </a:r>
          <a:r>
            <a:rPr lang="en-GB" sz="700" dirty="0" smtClean="0">
              <a:latin typeface="Arial" panose="020B0604020202020204" pitchFamily="34" charset="0"/>
            </a:rPr>
            <a:t>alpha=.05</a:t>
          </a:r>
          <a:endParaRPr lang="en-GB" sz="700" dirty="0">
            <a:latin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379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155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437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254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462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973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552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022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70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941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870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B91AE7-ADB6-4741-B7C5-2C19BC8FB529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0805F0-9719-4028-A766-FBB7F4532075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95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0391034"/>
              </p:ext>
            </p:extLst>
          </p:nvPr>
        </p:nvGraphicFramePr>
        <p:xfrm>
          <a:off x="6124575" y="204787"/>
          <a:ext cx="4114800" cy="32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9586148"/>
              </p:ext>
            </p:extLst>
          </p:nvPr>
        </p:nvGraphicFramePr>
        <p:xfrm>
          <a:off x="1947862" y="204787"/>
          <a:ext cx="4114800" cy="32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Grafic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137368"/>
              </p:ext>
            </p:extLst>
          </p:nvPr>
        </p:nvGraphicFramePr>
        <p:xfrm>
          <a:off x="1947862" y="3448049"/>
          <a:ext cx="4114800" cy="32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Grafico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0845067"/>
              </p:ext>
            </p:extLst>
          </p:nvPr>
        </p:nvGraphicFramePr>
        <p:xfrm>
          <a:off x="6124575" y="3448049"/>
          <a:ext cx="4114800" cy="32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Rettangolo 5"/>
          <p:cNvSpPr/>
          <p:nvPr/>
        </p:nvSpPr>
        <p:spPr>
          <a:xfrm>
            <a:off x="19050" y="6534834"/>
            <a:ext cx="6096000" cy="30777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400" dirty="0" err="1" smtClean="0"/>
              <a:t>Bonferroni</a:t>
            </a:r>
            <a:r>
              <a:rPr lang="en-US" sz="1400" dirty="0" smtClean="0"/>
              <a:t> corrected significance level: </a:t>
            </a:r>
            <a:r>
              <a:rPr lang="en-US" sz="1400" dirty="0"/>
              <a:t>.</a:t>
            </a:r>
            <a:r>
              <a:rPr lang="en-US" sz="1400" dirty="0" smtClean="0"/>
              <a:t>0167</a:t>
            </a:r>
            <a:r>
              <a:rPr lang="en-US" sz="1400" dirty="0" smtClean="0"/>
              <a:t>			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4354243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36</Words>
  <Application>Microsoft Office PowerPoint</Application>
  <PresentationFormat>Widescreen</PresentationFormat>
  <Paragraphs>8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MERA EMANUELA</dc:creator>
  <cp:lastModifiedBy>CAMERA EMANUELA</cp:lastModifiedBy>
  <cp:revision>8</cp:revision>
  <cp:lastPrinted>2021-09-06T14:59:19Z</cp:lastPrinted>
  <dcterms:created xsi:type="dcterms:W3CDTF">2021-09-06T13:46:08Z</dcterms:created>
  <dcterms:modified xsi:type="dcterms:W3CDTF">2021-11-15T15:08:24Z</dcterms:modified>
</cp:coreProperties>
</file>